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93" y="-3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449298566636169"/>
          <c:y val="3.3080424174174172E-2"/>
          <c:w val="0.69413286571109079"/>
          <c:h val="0.54407774962462463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1!$V$170</c:f>
              <c:strCache>
                <c:ptCount val="1"/>
                <c:pt idx="0">
                  <c:v>Control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circle"/>
            <c:size val="7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V$182:$V$190</c:f>
                <c:numCache>
                  <c:formatCode>General</c:formatCode>
                  <c:ptCount val="9"/>
                  <c:pt idx="0">
                    <c:v>1.9530602767053675E-2</c:v>
                  </c:pt>
                  <c:pt idx="1">
                    <c:v>2.5666666666666685E-2</c:v>
                  </c:pt>
                  <c:pt idx="2">
                    <c:v>3.0123818556823775E-2</c:v>
                  </c:pt>
                  <c:pt idx="3">
                    <c:v>3.0278338424982593E-2</c:v>
                  </c:pt>
                  <c:pt idx="4">
                    <c:v>3.5708697975578914E-2</c:v>
                  </c:pt>
                  <c:pt idx="5">
                    <c:v>3.6501141534660712E-2</c:v>
                  </c:pt>
                  <c:pt idx="6">
                    <c:v>4.1127174039124637E-2</c:v>
                  </c:pt>
                  <c:pt idx="7">
                    <c:v>4.0703535200001736E-2</c:v>
                  </c:pt>
                  <c:pt idx="8">
                    <c:v>4.532965671365468E-2</c:v>
                  </c:pt>
                </c:numCache>
              </c:numRef>
            </c:plus>
            <c:minus>
              <c:numRef>
                <c:f>Sheet1!$V$182:$V$190</c:f>
                <c:numCache>
                  <c:formatCode>General</c:formatCode>
                  <c:ptCount val="9"/>
                  <c:pt idx="0">
                    <c:v>1.9530602767053675E-2</c:v>
                  </c:pt>
                  <c:pt idx="1">
                    <c:v>2.5666666666666685E-2</c:v>
                  </c:pt>
                  <c:pt idx="2">
                    <c:v>3.0123818556823775E-2</c:v>
                  </c:pt>
                  <c:pt idx="3">
                    <c:v>3.0278338424982593E-2</c:v>
                  </c:pt>
                  <c:pt idx="4">
                    <c:v>3.5708697975578914E-2</c:v>
                  </c:pt>
                  <c:pt idx="5">
                    <c:v>3.6501141534660712E-2</c:v>
                  </c:pt>
                  <c:pt idx="6">
                    <c:v>4.1127174039124637E-2</c:v>
                  </c:pt>
                  <c:pt idx="7">
                    <c:v>4.0703535200001736E-2</c:v>
                  </c:pt>
                  <c:pt idx="8">
                    <c:v>4.532965671365468E-2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1!$U$171:$U$179</c:f>
              <c:numCache>
                <c:formatCode>0.000</c:formatCode>
                <c:ptCount val="9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45</c:v>
                </c:pt>
                <c:pt idx="4">
                  <c:v>60</c:v>
                </c:pt>
                <c:pt idx="5">
                  <c:v>75</c:v>
                </c:pt>
                <c:pt idx="6">
                  <c:v>90</c:v>
                </c:pt>
                <c:pt idx="7">
                  <c:v>105</c:v>
                </c:pt>
                <c:pt idx="8">
                  <c:v>120</c:v>
                </c:pt>
              </c:numCache>
            </c:numRef>
          </c:xVal>
          <c:yVal>
            <c:numRef>
              <c:f>Sheet1!$V$171:$V$179</c:f>
              <c:numCache>
                <c:formatCode>0.000</c:formatCode>
                <c:ptCount val="9"/>
                <c:pt idx="0">
                  <c:v>1.1233333333333333</c:v>
                </c:pt>
                <c:pt idx="1">
                  <c:v>1.1066666666666667</c:v>
                </c:pt>
                <c:pt idx="2">
                  <c:v>1.0913333333333333</c:v>
                </c:pt>
                <c:pt idx="3">
                  <c:v>1.0696666666666668</c:v>
                </c:pt>
                <c:pt idx="4">
                  <c:v>1.0466666666666666</c:v>
                </c:pt>
                <c:pt idx="5">
                  <c:v>1.0399999999999998</c:v>
                </c:pt>
                <c:pt idx="6">
                  <c:v>1.0323333333333335</c:v>
                </c:pt>
                <c:pt idx="7">
                  <c:v>1.0276666666666667</c:v>
                </c:pt>
                <c:pt idx="8">
                  <c:v>1.0173333333333332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1!$W$170</c:f>
              <c:strCache>
                <c:ptCount val="1"/>
                <c:pt idx="0">
                  <c:v>HL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W$182:$W$190</c:f>
                <c:numCache>
                  <c:formatCode>General</c:formatCode>
                  <c:ptCount val="9"/>
                  <c:pt idx="0">
                    <c:v>3.4372146346197882E-2</c:v>
                  </c:pt>
                  <c:pt idx="1">
                    <c:v>3.9557272122553874E-2</c:v>
                  </c:pt>
                  <c:pt idx="2">
                    <c:v>4.1932485418030421E-2</c:v>
                  </c:pt>
                  <c:pt idx="3">
                    <c:v>2.9356051808405358E-2</c:v>
                  </c:pt>
                  <c:pt idx="4">
                    <c:v>4.1549167661137726E-2</c:v>
                  </c:pt>
                  <c:pt idx="5">
                    <c:v>4.4856561516807225E-2</c:v>
                  </c:pt>
                  <c:pt idx="6">
                    <c:v>4.7188746304365606E-2</c:v>
                  </c:pt>
                  <c:pt idx="7">
                    <c:v>4.7698124817555636E-2</c:v>
                  </c:pt>
                  <c:pt idx="8">
                    <c:v>4.8885353407516527E-2</c:v>
                  </c:pt>
                </c:numCache>
              </c:numRef>
            </c:plus>
            <c:minus>
              <c:numRef>
                <c:f>Sheet1!$W$182:$W$190</c:f>
                <c:numCache>
                  <c:formatCode>General</c:formatCode>
                  <c:ptCount val="9"/>
                  <c:pt idx="0">
                    <c:v>3.4372146346197882E-2</c:v>
                  </c:pt>
                  <c:pt idx="1">
                    <c:v>3.9557272122553874E-2</c:v>
                  </c:pt>
                  <c:pt idx="2">
                    <c:v>4.1932485418030421E-2</c:v>
                  </c:pt>
                  <c:pt idx="3">
                    <c:v>2.9356051808405358E-2</c:v>
                  </c:pt>
                  <c:pt idx="4">
                    <c:v>4.1549167661137726E-2</c:v>
                  </c:pt>
                  <c:pt idx="5">
                    <c:v>4.4856561516807225E-2</c:v>
                  </c:pt>
                  <c:pt idx="6">
                    <c:v>4.7188746304365606E-2</c:v>
                  </c:pt>
                  <c:pt idx="7">
                    <c:v>4.7698124817555636E-2</c:v>
                  </c:pt>
                  <c:pt idx="8">
                    <c:v>4.8885353407516527E-2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1!$U$171:$U$179</c:f>
              <c:numCache>
                <c:formatCode>0.000</c:formatCode>
                <c:ptCount val="9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45</c:v>
                </c:pt>
                <c:pt idx="4">
                  <c:v>60</c:v>
                </c:pt>
                <c:pt idx="5">
                  <c:v>75</c:v>
                </c:pt>
                <c:pt idx="6">
                  <c:v>90</c:v>
                </c:pt>
                <c:pt idx="7">
                  <c:v>105</c:v>
                </c:pt>
                <c:pt idx="8">
                  <c:v>120</c:v>
                </c:pt>
              </c:numCache>
            </c:numRef>
          </c:xVal>
          <c:yVal>
            <c:numRef>
              <c:f>Sheet1!$W$171:$W$179</c:f>
              <c:numCache>
                <c:formatCode>0.000</c:formatCode>
                <c:ptCount val="9"/>
                <c:pt idx="0">
                  <c:v>1.1023333333333334</c:v>
                </c:pt>
                <c:pt idx="1">
                  <c:v>1.0273333333333332</c:v>
                </c:pt>
                <c:pt idx="2">
                  <c:v>0.96200000000000008</c:v>
                </c:pt>
                <c:pt idx="3">
                  <c:v>0.88566666666666671</c:v>
                </c:pt>
                <c:pt idx="4">
                  <c:v>0.80700000000000005</c:v>
                </c:pt>
                <c:pt idx="5">
                  <c:v>0.73966666666666658</c:v>
                </c:pt>
                <c:pt idx="6">
                  <c:v>0.68133333333333324</c:v>
                </c:pt>
                <c:pt idx="7">
                  <c:v>0.62833333333333341</c:v>
                </c:pt>
                <c:pt idx="8">
                  <c:v>0.58233333333333326</c:v>
                </c:pt>
              </c:numCache>
            </c:numRef>
          </c:yVal>
          <c:smooth val="1"/>
        </c:ser>
        <c:ser>
          <c:idx val="2"/>
          <c:order val="2"/>
          <c:tx>
            <c:strRef>
              <c:f>Sheet1!$X$170</c:f>
              <c:strCache>
                <c:ptCount val="1"/>
                <c:pt idx="0">
                  <c:v>HL + rNm-ACPII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circle"/>
            <c:size val="7"/>
            <c:spPr>
              <a:solidFill>
                <a:schemeClr val="bg1">
                  <a:lumMod val="65000"/>
                </a:schemeClr>
              </a:solidFill>
              <a:ln w="1270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X$182:$X$190</c:f>
                <c:numCache>
                  <c:formatCode>General</c:formatCode>
                  <c:ptCount val="9"/>
                  <c:pt idx="0">
                    <c:v>6.8222947186311802E-3</c:v>
                  </c:pt>
                  <c:pt idx="1">
                    <c:v>2.0043961030687674E-2</c:v>
                  </c:pt>
                  <c:pt idx="2">
                    <c:v>1.8896406002411017E-2</c:v>
                  </c:pt>
                  <c:pt idx="3">
                    <c:v>1.5468427412272659E-2</c:v>
                  </c:pt>
                  <c:pt idx="4">
                    <c:v>2.1939281789271226E-2</c:v>
                  </c:pt>
                  <c:pt idx="5">
                    <c:v>2.2311794785649305E-2</c:v>
                  </c:pt>
                  <c:pt idx="6">
                    <c:v>2.3885513526813021E-2</c:v>
                  </c:pt>
                  <c:pt idx="7">
                    <c:v>2.3192411384247758E-2</c:v>
                  </c:pt>
                  <c:pt idx="8">
                    <c:v>2.1426775096901364E-2</c:v>
                  </c:pt>
                </c:numCache>
              </c:numRef>
            </c:plus>
            <c:minus>
              <c:numRef>
                <c:f>Sheet1!$X$182:$X$190</c:f>
                <c:numCache>
                  <c:formatCode>General</c:formatCode>
                  <c:ptCount val="9"/>
                  <c:pt idx="0">
                    <c:v>6.8222947186311802E-3</c:v>
                  </c:pt>
                  <c:pt idx="1">
                    <c:v>2.0043961030687674E-2</c:v>
                  </c:pt>
                  <c:pt idx="2">
                    <c:v>1.8896406002411017E-2</c:v>
                  </c:pt>
                  <c:pt idx="3">
                    <c:v>1.5468427412272659E-2</c:v>
                  </c:pt>
                  <c:pt idx="4">
                    <c:v>2.1939281789271226E-2</c:v>
                  </c:pt>
                  <c:pt idx="5">
                    <c:v>2.2311794785649305E-2</c:v>
                  </c:pt>
                  <c:pt idx="6">
                    <c:v>2.3885513526813021E-2</c:v>
                  </c:pt>
                  <c:pt idx="7">
                    <c:v>2.3192411384247758E-2</c:v>
                  </c:pt>
                  <c:pt idx="8">
                    <c:v>2.1426775096901364E-2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1!$U$171:$U$179</c:f>
              <c:numCache>
                <c:formatCode>0.000</c:formatCode>
                <c:ptCount val="9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45</c:v>
                </c:pt>
                <c:pt idx="4">
                  <c:v>60</c:v>
                </c:pt>
                <c:pt idx="5">
                  <c:v>75</c:v>
                </c:pt>
                <c:pt idx="6">
                  <c:v>90</c:v>
                </c:pt>
                <c:pt idx="7">
                  <c:v>105</c:v>
                </c:pt>
                <c:pt idx="8">
                  <c:v>120</c:v>
                </c:pt>
              </c:numCache>
            </c:numRef>
          </c:xVal>
          <c:yVal>
            <c:numRef>
              <c:f>Sheet1!$X$171:$X$179</c:f>
              <c:numCache>
                <c:formatCode>0.000</c:formatCode>
                <c:ptCount val="9"/>
                <c:pt idx="0">
                  <c:v>1.1234012345679012</c:v>
                </c:pt>
                <c:pt idx="1">
                  <c:v>1.1148981481481479</c:v>
                </c:pt>
                <c:pt idx="2">
                  <c:v>1.0930092592592593</c:v>
                </c:pt>
                <c:pt idx="3">
                  <c:v>1.0777049382716049</c:v>
                </c:pt>
                <c:pt idx="4">
                  <c:v>1.0635895061728393</c:v>
                </c:pt>
                <c:pt idx="5">
                  <c:v>1.051962962962963</c:v>
                </c:pt>
                <c:pt idx="6">
                  <c:v>1.0417530864197531</c:v>
                </c:pt>
                <c:pt idx="7">
                  <c:v>1.0342870370370369</c:v>
                </c:pt>
                <c:pt idx="8">
                  <c:v>1.0226049382716049</c:v>
                </c:pt>
              </c:numCache>
            </c:numRef>
          </c:yVal>
          <c:smooth val="1"/>
        </c:ser>
        <c:ser>
          <c:idx val="3"/>
          <c:order val="3"/>
          <c:tx>
            <c:strRef>
              <c:f>Sheet1!$Y$170</c:f>
              <c:strCache>
                <c:ptCount val="1"/>
                <c:pt idx="0">
                  <c:v>HL + rNm-ACPII + Ab(Lip-II)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triangle"/>
            <c:size val="7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Y$182:$Y$190</c:f>
                <c:numCache>
                  <c:formatCode>General</c:formatCode>
                  <c:ptCount val="9"/>
                  <c:pt idx="0">
                    <c:v>2.4126978905596813E-2</c:v>
                  </c:pt>
                  <c:pt idx="1">
                    <c:v>2.6522527112710158E-2</c:v>
                  </c:pt>
                  <c:pt idx="2">
                    <c:v>4.9763886950724048E-2</c:v>
                  </c:pt>
                  <c:pt idx="3">
                    <c:v>4.8013886880082214E-2</c:v>
                  </c:pt>
                  <c:pt idx="4">
                    <c:v>5.1595650118116669E-2</c:v>
                  </c:pt>
                  <c:pt idx="5">
                    <c:v>4.1016256939576189E-2</c:v>
                  </c:pt>
                  <c:pt idx="6">
                    <c:v>5.4975752230718496E-2</c:v>
                  </c:pt>
                  <c:pt idx="7">
                    <c:v>4.9319817968483878E-2</c:v>
                  </c:pt>
                  <c:pt idx="8">
                    <c:v>5.1733290377988891E-2</c:v>
                  </c:pt>
                </c:numCache>
              </c:numRef>
            </c:plus>
            <c:minus>
              <c:numRef>
                <c:f>Sheet1!$Y$182:$Y$190</c:f>
                <c:numCache>
                  <c:formatCode>General</c:formatCode>
                  <c:ptCount val="9"/>
                  <c:pt idx="0">
                    <c:v>2.4126978905596813E-2</c:v>
                  </c:pt>
                  <c:pt idx="1">
                    <c:v>2.6522527112710158E-2</c:v>
                  </c:pt>
                  <c:pt idx="2">
                    <c:v>4.9763886950724048E-2</c:v>
                  </c:pt>
                  <c:pt idx="3">
                    <c:v>4.8013886880082214E-2</c:v>
                  </c:pt>
                  <c:pt idx="4">
                    <c:v>5.1595650118116669E-2</c:v>
                  </c:pt>
                  <c:pt idx="5">
                    <c:v>4.1016256939576189E-2</c:v>
                  </c:pt>
                  <c:pt idx="6">
                    <c:v>5.4975752230718496E-2</c:v>
                  </c:pt>
                  <c:pt idx="7">
                    <c:v>4.9319817968483878E-2</c:v>
                  </c:pt>
                  <c:pt idx="8">
                    <c:v>5.1733290377988891E-2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1!$U$171:$U$179</c:f>
              <c:numCache>
                <c:formatCode>0.000</c:formatCode>
                <c:ptCount val="9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45</c:v>
                </c:pt>
                <c:pt idx="4">
                  <c:v>60</c:v>
                </c:pt>
                <c:pt idx="5">
                  <c:v>75</c:v>
                </c:pt>
                <c:pt idx="6">
                  <c:v>90</c:v>
                </c:pt>
                <c:pt idx="7">
                  <c:v>105</c:v>
                </c:pt>
                <c:pt idx="8">
                  <c:v>120</c:v>
                </c:pt>
              </c:numCache>
            </c:numRef>
          </c:xVal>
          <c:yVal>
            <c:numRef>
              <c:f>Sheet1!$Y$171:$Y$179</c:f>
              <c:numCache>
                <c:formatCode>0.000</c:formatCode>
                <c:ptCount val="9"/>
                <c:pt idx="0">
                  <c:v>1.0833333333333333</c:v>
                </c:pt>
                <c:pt idx="1">
                  <c:v>1.0363333333333333</c:v>
                </c:pt>
                <c:pt idx="2">
                  <c:v>0.95166666666666655</c:v>
                </c:pt>
                <c:pt idx="3">
                  <c:v>0.89800000000000002</c:v>
                </c:pt>
                <c:pt idx="4">
                  <c:v>0.82466666666666677</c:v>
                </c:pt>
                <c:pt idx="5">
                  <c:v>0.76200000000000001</c:v>
                </c:pt>
                <c:pt idx="6">
                  <c:v>0.70199999999999996</c:v>
                </c:pt>
                <c:pt idx="7">
                  <c:v>0.66066666666666674</c:v>
                </c:pt>
                <c:pt idx="8">
                  <c:v>0.61</c:v>
                </c:pt>
              </c:numCache>
            </c:numRef>
          </c:yVal>
          <c:smooth val="1"/>
        </c:ser>
        <c:ser>
          <c:idx val="4"/>
          <c:order val="4"/>
          <c:tx>
            <c:strRef>
              <c:f>Sheet1!$AC$170</c:f>
              <c:strCache>
                <c:ptCount val="1"/>
                <c:pt idx="0">
                  <c:v>HL + rNm-ACPII + Ab(Sal-II)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triangle"/>
            <c:size val="7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AC$182:$AC$190</c:f>
                <c:numCache>
                  <c:formatCode>General</c:formatCode>
                  <c:ptCount val="9"/>
                  <c:pt idx="0">
                    <c:v>1.8435762525373704E-2</c:v>
                  </c:pt>
                  <c:pt idx="1">
                    <c:v>1.7575190540385685E-2</c:v>
                  </c:pt>
                  <c:pt idx="2">
                    <c:v>2.1198610053269711E-2</c:v>
                  </c:pt>
                  <c:pt idx="3">
                    <c:v>9.5611959239491427E-3</c:v>
                  </c:pt>
                  <c:pt idx="4">
                    <c:v>1.6573221081660809E-2</c:v>
                  </c:pt>
                  <c:pt idx="5">
                    <c:v>1.6795550382021754E-2</c:v>
                  </c:pt>
                  <c:pt idx="6">
                    <c:v>2.0147204078380831E-2</c:v>
                  </c:pt>
                  <c:pt idx="7">
                    <c:v>1.9817458669401211E-2</c:v>
                  </c:pt>
                  <c:pt idx="8">
                    <c:v>2.0623226401482144E-2</c:v>
                  </c:pt>
                </c:numCache>
              </c:numRef>
            </c:plus>
            <c:minus>
              <c:numRef>
                <c:f>Sheet1!$AC$182:$AC$190</c:f>
                <c:numCache>
                  <c:formatCode>General</c:formatCode>
                  <c:ptCount val="9"/>
                  <c:pt idx="0">
                    <c:v>1.8435762525373704E-2</c:v>
                  </c:pt>
                  <c:pt idx="1">
                    <c:v>1.7575190540385685E-2</c:v>
                  </c:pt>
                  <c:pt idx="2">
                    <c:v>2.1198610053269711E-2</c:v>
                  </c:pt>
                  <c:pt idx="3">
                    <c:v>9.5611959239491427E-3</c:v>
                  </c:pt>
                  <c:pt idx="4">
                    <c:v>1.6573221081660809E-2</c:v>
                  </c:pt>
                  <c:pt idx="5">
                    <c:v>1.6795550382021754E-2</c:v>
                  </c:pt>
                  <c:pt idx="6">
                    <c:v>2.0147204078380831E-2</c:v>
                  </c:pt>
                  <c:pt idx="7">
                    <c:v>1.9817458669401211E-2</c:v>
                  </c:pt>
                  <c:pt idx="8">
                    <c:v>2.0623226401482144E-2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1!$U$171:$U$179</c:f>
              <c:numCache>
                <c:formatCode>0.000</c:formatCode>
                <c:ptCount val="9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45</c:v>
                </c:pt>
                <c:pt idx="4">
                  <c:v>60</c:v>
                </c:pt>
                <c:pt idx="5">
                  <c:v>75</c:v>
                </c:pt>
                <c:pt idx="6">
                  <c:v>90</c:v>
                </c:pt>
                <c:pt idx="7">
                  <c:v>105</c:v>
                </c:pt>
                <c:pt idx="8">
                  <c:v>120</c:v>
                </c:pt>
              </c:numCache>
            </c:numRef>
          </c:xVal>
          <c:yVal>
            <c:numRef>
              <c:f>Sheet1!$AC$171:$AC$179</c:f>
              <c:numCache>
                <c:formatCode>0.000</c:formatCode>
                <c:ptCount val="9"/>
                <c:pt idx="0">
                  <c:v>1.1271180555555553</c:v>
                </c:pt>
                <c:pt idx="1">
                  <c:v>1.0887805555555556</c:v>
                </c:pt>
                <c:pt idx="2">
                  <c:v>1.0488006944444443</c:v>
                </c:pt>
                <c:pt idx="3">
                  <c:v>1.0022506944444445</c:v>
                </c:pt>
                <c:pt idx="4">
                  <c:v>0.95843194444444446</c:v>
                </c:pt>
                <c:pt idx="5">
                  <c:v>0.9289243055555555</c:v>
                </c:pt>
                <c:pt idx="6">
                  <c:v>0.89695000000000003</c:v>
                </c:pt>
                <c:pt idx="7">
                  <c:v>0.87138958333333338</c:v>
                </c:pt>
                <c:pt idx="8">
                  <c:v>0.84645138888888882</c:v>
                </c:pt>
              </c:numCache>
            </c:numRef>
          </c:yVal>
          <c:smooth val="1"/>
        </c:ser>
        <c:ser>
          <c:idx val="5"/>
          <c:order val="5"/>
          <c:tx>
            <c:strRef>
              <c:f>Sheet1!$AG$170</c:f>
              <c:strCache>
                <c:ptCount val="1"/>
                <c:pt idx="0">
                  <c:v>HL + rNm-ACPII + Ab(Al-II)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triangle"/>
            <c:size val="7"/>
            <c:spPr>
              <a:solidFill>
                <a:schemeClr val="bg1">
                  <a:lumMod val="65000"/>
                </a:schemeClr>
              </a:solidFill>
              <a:ln w="1270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AG$182:$AG$190</c:f>
                <c:numCache>
                  <c:formatCode>General</c:formatCode>
                  <c:ptCount val="9"/>
                  <c:pt idx="0">
                    <c:v>2.6874493535279455E-2</c:v>
                  </c:pt>
                  <c:pt idx="1">
                    <c:v>1.9930165888563941E-2</c:v>
                  </c:pt>
                  <c:pt idx="2">
                    <c:v>2.5520638018904931E-2</c:v>
                  </c:pt>
                  <c:pt idx="3">
                    <c:v>2.2824051616133472E-2</c:v>
                  </c:pt>
                  <c:pt idx="4">
                    <c:v>3.5828936853462265E-2</c:v>
                  </c:pt>
                  <c:pt idx="5">
                    <c:v>3.7686666913380948E-2</c:v>
                  </c:pt>
                  <c:pt idx="6">
                    <c:v>4.7059719824264504E-2</c:v>
                  </c:pt>
                  <c:pt idx="7">
                    <c:v>4.7738447818054648E-2</c:v>
                  </c:pt>
                  <c:pt idx="8">
                    <c:v>5.1548371146926376E-2</c:v>
                  </c:pt>
                </c:numCache>
              </c:numRef>
            </c:plus>
            <c:minus>
              <c:numRef>
                <c:f>Sheet1!$AG$182:$AG$190</c:f>
                <c:numCache>
                  <c:formatCode>General</c:formatCode>
                  <c:ptCount val="9"/>
                  <c:pt idx="0">
                    <c:v>2.6874493535279455E-2</c:v>
                  </c:pt>
                  <c:pt idx="1">
                    <c:v>1.9930165888563941E-2</c:v>
                  </c:pt>
                  <c:pt idx="2">
                    <c:v>2.5520638018904931E-2</c:v>
                  </c:pt>
                  <c:pt idx="3">
                    <c:v>2.2824051616133472E-2</c:v>
                  </c:pt>
                  <c:pt idx="4">
                    <c:v>3.5828936853462265E-2</c:v>
                  </c:pt>
                  <c:pt idx="5">
                    <c:v>3.7686666913380948E-2</c:v>
                  </c:pt>
                  <c:pt idx="6">
                    <c:v>4.7059719824264504E-2</c:v>
                  </c:pt>
                  <c:pt idx="7">
                    <c:v>4.7738447818054648E-2</c:v>
                  </c:pt>
                  <c:pt idx="8">
                    <c:v>5.1548371146926376E-2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1!$U$171:$U$179</c:f>
              <c:numCache>
                <c:formatCode>0.000</c:formatCode>
                <c:ptCount val="9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45</c:v>
                </c:pt>
                <c:pt idx="4">
                  <c:v>60</c:v>
                </c:pt>
                <c:pt idx="5">
                  <c:v>75</c:v>
                </c:pt>
                <c:pt idx="6">
                  <c:v>90</c:v>
                </c:pt>
                <c:pt idx="7">
                  <c:v>105</c:v>
                </c:pt>
                <c:pt idx="8">
                  <c:v>120</c:v>
                </c:pt>
              </c:numCache>
            </c:numRef>
          </c:xVal>
          <c:yVal>
            <c:numRef>
              <c:f>Sheet1!$AG$171:$AG$179</c:f>
              <c:numCache>
                <c:formatCode>0.000</c:formatCode>
                <c:ptCount val="9"/>
                <c:pt idx="0">
                  <c:v>1.1008583333333333</c:v>
                </c:pt>
                <c:pt idx="1">
                  <c:v>1.0124611111111113</c:v>
                </c:pt>
                <c:pt idx="2">
                  <c:v>0.93044305555555551</c:v>
                </c:pt>
                <c:pt idx="3">
                  <c:v>0.87383750000000004</c:v>
                </c:pt>
                <c:pt idx="4">
                  <c:v>0.80307777777777778</c:v>
                </c:pt>
                <c:pt idx="5">
                  <c:v>0.74685138888888891</c:v>
                </c:pt>
                <c:pt idx="6">
                  <c:v>0.69454722222222232</c:v>
                </c:pt>
                <c:pt idx="7">
                  <c:v>0.65455972222222225</c:v>
                </c:pt>
                <c:pt idx="8">
                  <c:v>0.61188888888888882</c:v>
                </c:pt>
              </c:numCache>
            </c:numRef>
          </c:yVal>
          <c:smooth val="1"/>
        </c:ser>
        <c:ser>
          <c:idx val="6"/>
          <c:order val="6"/>
          <c:tx>
            <c:strRef>
              <c:f>Sheet1!$AK$170</c:f>
              <c:strCache>
                <c:ptCount val="1"/>
                <c:pt idx="0">
                  <c:v>HL + rNm-ACPII + NMS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square"/>
            <c:size val="7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AK$182:$AK$190</c:f>
                <c:numCache>
                  <c:formatCode>General</c:formatCode>
                  <c:ptCount val="9"/>
                  <c:pt idx="0">
                    <c:v>9.6222015510284593E-3</c:v>
                  </c:pt>
                  <c:pt idx="1">
                    <c:v>5.2779320965092866E-3</c:v>
                  </c:pt>
                  <c:pt idx="2">
                    <c:v>5.6067624635219937E-3</c:v>
                  </c:pt>
                  <c:pt idx="3">
                    <c:v>7.0862738994324484E-3</c:v>
                  </c:pt>
                  <c:pt idx="4">
                    <c:v>7.7514324531306146E-3</c:v>
                  </c:pt>
                  <c:pt idx="5">
                    <c:v>8.3193916299153878E-3</c:v>
                  </c:pt>
                  <c:pt idx="6">
                    <c:v>9.3455653604649462E-3</c:v>
                  </c:pt>
                  <c:pt idx="7">
                    <c:v>9.6179237968422628E-3</c:v>
                  </c:pt>
                  <c:pt idx="8">
                    <c:v>1.1452277674034169E-2</c:v>
                  </c:pt>
                </c:numCache>
              </c:numRef>
            </c:plus>
            <c:minus>
              <c:numRef>
                <c:f>Sheet1!$AK$182:$AK$190</c:f>
                <c:numCache>
                  <c:formatCode>General</c:formatCode>
                  <c:ptCount val="9"/>
                  <c:pt idx="0">
                    <c:v>9.6222015510284593E-3</c:v>
                  </c:pt>
                  <c:pt idx="1">
                    <c:v>5.2779320965092866E-3</c:v>
                  </c:pt>
                  <c:pt idx="2">
                    <c:v>5.6067624635219937E-3</c:v>
                  </c:pt>
                  <c:pt idx="3">
                    <c:v>7.0862738994324484E-3</c:v>
                  </c:pt>
                  <c:pt idx="4">
                    <c:v>7.7514324531306146E-3</c:v>
                  </c:pt>
                  <c:pt idx="5">
                    <c:v>8.3193916299153878E-3</c:v>
                  </c:pt>
                  <c:pt idx="6">
                    <c:v>9.3455653604649462E-3</c:v>
                  </c:pt>
                  <c:pt idx="7">
                    <c:v>9.6179237968422628E-3</c:v>
                  </c:pt>
                  <c:pt idx="8">
                    <c:v>1.1452277674034169E-2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1!$U$171:$U$179</c:f>
              <c:numCache>
                <c:formatCode>0.000</c:formatCode>
                <c:ptCount val="9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45</c:v>
                </c:pt>
                <c:pt idx="4">
                  <c:v>60</c:v>
                </c:pt>
                <c:pt idx="5">
                  <c:v>75</c:v>
                </c:pt>
                <c:pt idx="6">
                  <c:v>90</c:v>
                </c:pt>
                <c:pt idx="7">
                  <c:v>105</c:v>
                </c:pt>
                <c:pt idx="8">
                  <c:v>120</c:v>
                </c:pt>
              </c:numCache>
            </c:numRef>
          </c:xVal>
          <c:yVal>
            <c:numRef>
              <c:f>Sheet1!$AK$171:$AK$179</c:f>
              <c:numCache>
                <c:formatCode>0.000</c:formatCode>
                <c:ptCount val="9"/>
                <c:pt idx="0">
                  <c:v>1.1405185185185185</c:v>
                </c:pt>
                <c:pt idx="1">
                  <c:v>1.1211574074074073</c:v>
                </c:pt>
                <c:pt idx="2">
                  <c:v>1.0950462962962961</c:v>
                </c:pt>
                <c:pt idx="3">
                  <c:v>1.0704166666666668</c:v>
                </c:pt>
                <c:pt idx="4">
                  <c:v>1.0541296296296296</c:v>
                </c:pt>
                <c:pt idx="5">
                  <c:v>1.0380740740740741</c:v>
                </c:pt>
                <c:pt idx="6">
                  <c:v>1.0251759259259261</c:v>
                </c:pt>
                <c:pt idx="7">
                  <c:v>1.011037037037037</c:v>
                </c:pt>
                <c:pt idx="8">
                  <c:v>0.99164814814814806</c:v>
                </c:pt>
              </c:numCache>
            </c:numRef>
          </c:yVal>
          <c:smooth val="1"/>
        </c:ser>
        <c:ser>
          <c:idx val="7"/>
          <c:order val="7"/>
          <c:tx>
            <c:strRef>
              <c:f>Sheet1!$AM$170</c:f>
              <c:strCache>
                <c:ptCount val="1"/>
                <c:pt idx="0">
                  <c:v>HL + rNm-MIP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square"/>
            <c:size val="7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AM$182:$AM$190</c:f>
                <c:numCache>
                  <c:formatCode>General</c:formatCode>
                  <c:ptCount val="9"/>
                  <c:pt idx="0">
                    <c:v>2.574158033869197E-2</c:v>
                  </c:pt>
                  <c:pt idx="1">
                    <c:v>2.1613351069291496E-2</c:v>
                  </c:pt>
                  <c:pt idx="2">
                    <c:v>2.5474898116141287E-2</c:v>
                  </c:pt>
                  <c:pt idx="3">
                    <c:v>1.4946404830631062E-2</c:v>
                  </c:pt>
                  <c:pt idx="4">
                    <c:v>2.5848554655488527E-2</c:v>
                  </c:pt>
                  <c:pt idx="5">
                    <c:v>3.0095759495040727E-2</c:v>
                  </c:pt>
                  <c:pt idx="6">
                    <c:v>3.680801637475787E-2</c:v>
                  </c:pt>
                  <c:pt idx="7">
                    <c:v>3.8125512974691037E-2</c:v>
                  </c:pt>
                  <c:pt idx="8">
                    <c:v>4.1818390425478809E-2</c:v>
                  </c:pt>
                </c:numCache>
              </c:numRef>
            </c:plus>
            <c:minus>
              <c:numRef>
                <c:f>Sheet1!$AM$182:$AM$190</c:f>
                <c:numCache>
                  <c:formatCode>General</c:formatCode>
                  <c:ptCount val="9"/>
                  <c:pt idx="0">
                    <c:v>2.574158033869197E-2</c:v>
                  </c:pt>
                  <c:pt idx="1">
                    <c:v>2.1613351069291496E-2</c:v>
                  </c:pt>
                  <c:pt idx="2">
                    <c:v>2.5474898116141287E-2</c:v>
                  </c:pt>
                  <c:pt idx="3">
                    <c:v>1.4946404830631062E-2</c:v>
                  </c:pt>
                  <c:pt idx="4">
                    <c:v>2.5848554655488527E-2</c:v>
                  </c:pt>
                  <c:pt idx="5">
                    <c:v>3.0095759495040727E-2</c:v>
                  </c:pt>
                  <c:pt idx="6">
                    <c:v>3.680801637475787E-2</c:v>
                  </c:pt>
                  <c:pt idx="7">
                    <c:v>3.8125512974691037E-2</c:v>
                  </c:pt>
                  <c:pt idx="8">
                    <c:v>4.1818390425478809E-2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1!$U$171:$U$179</c:f>
              <c:numCache>
                <c:formatCode>0.000</c:formatCode>
                <c:ptCount val="9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45</c:v>
                </c:pt>
                <c:pt idx="4">
                  <c:v>60</c:v>
                </c:pt>
                <c:pt idx="5">
                  <c:v>75</c:v>
                </c:pt>
                <c:pt idx="6">
                  <c:v>90</c:v>
                </c:pt>
                <c:pt idx="7">
                  <c:v>105</c:v>
                </c:pt>
                <c:pt idx="8">
                  <c:v>120</c:v>
                </c:pt>
              </c:numCache>
            </c:numRef>
          </c:xVal>
          <c:yVal>
            <c:numRef>
              <c:f>Sheet1!$AM$171:$AM$179</c:f>
              <c:numCache>
                <c:formatCode>0.000</c:formatCode>
                <c:ptCount val="9"/>
                <c:pt idx="0">
                  <c:v>1.1087749999999998</c:v>
                </c:pt>
                <c:pt idx="1">
                  <c:v>1.0081833333333334</c:v>
                </c:pt>
                <c:pt idx="2">
                  <c:v>0.92742916666666664</c:v>
                </c:pt>
                <c:pt idx="3">
                  <c:v>0.85987916666666686</c:v>
                </c:pt>
                <c:pt idx="4">
                  <c:v>0.79513333333333325</c:v>
                </c:pt>
                <c:pt idx="5">
                  <c:v>0.74458750000000007</c:v>
                </c:pt>
                <c:pt idx="6">
                  <c:v>0.69490833333333335</c:v>
                </c:pt>
                <c:pt idx="7">
                  <c:v>0.65471249999999992</c:v>
                </c:pt>
                <c:pt idx="8">
                  <c:v>0.61466666666666669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9992704"/>
        <c:axId val="210007168"/>
      </c:scatterChart>
      <c:valAx>
        <c:axId val="209992704"/>
        <c:scaling>
          <c:orientation val="minMax"/>
          <c:max val="13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sz="12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200">
                    <a:latin typeface="Arial" panose="020B0604020202020204" pitchFamily="34" charset="0"/>
                    <a:cs typeface="Arial" panose="020B0604020202020204" pitchFamily="34" charset="0"/>
                  </a:rPr>
                  <a:t>Time (min)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10007168"/>
        <c:crosses val="autoZero"/>
        <c:crossBetween val="midCat"/>
        <c:majorUnit val="15"/>
      </c:valAx>
      <c:valAx>
        <c:axId val="210007168"/>
        <c:scaling>
          <c:orientation val="minMax"/>
          <c:max val="1.2"/>
          <c:min val="0.4"/>
        </c:scaling>
        <c:delete val="0"/>
        <c:axPos val="l"/>
        <c:title>
          <c:tx>
            <c:rich>
              <a:bodyPr rot="-5400000" vert="horz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200" b="1" i="0" u="none" strike="noStrike" kern="1200" baseline="0">
                    <a:solidFill>
                      <a:prstClr val="black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 b="1" i="0" baseline="0" dirty="0" smtClean="0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Abs (</a:t>
                </a:r>
                <a:r>
                  <a:rPr lang="el-GR" sz="1200" b="1" i="0" baseline="0" dirty="0" smtClean="0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λ</a:t>
                </a:r>
                <a:r>
                  <a:rPr lang="en-GB" sz="1200" b="1" i="0" baseline="0" dirty="0" smtClean="0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 = 595 nm)</a:t>
                </a:r>
                <a:endParaRPr lang="en-GB" sz="1200" dirty="0" smtClean="0"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</c:title>
        <c:numFmt formatCode="0.0" sourceLinked="0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09992704"/>
        <c:crosses val="autoZero"/>
        <c:crossBetween val="midCat"/>
        <c:majorUnit val="0.1"/>
      </c:valAx>
    </c:plotArea>
    <c:legend>
      <c:legendPos val="b"/>
      <c:layout>
        <c:manualLayout>
          <c:xMode val="edge"/>
          <c:yMode val="edge"/>
          <c:x val="0.28191038934634544"/>
          <c:y val="0.72822588213213213"/>
          <c:w val="0.5523731828809596"/>
          <c:h val="0.26879457582582583"/>
        </c:manualLayout>
      </c:layout>
      <c:overlay val="0"/>
      <c:txPr>
        <a:bodyPr/>
        <a:lstStyle/>
        <a:p>
          <a:pPr>
            <a:defRPr sz="1000">
              <a:latin typeface="Arial" panose="020B0604020202020204" pitchFamily="34" charset="0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609064590196667"/>
          <c:y val="3.4081860269360269E-2"/>
          <c:w val="0.67603124688030347"/>
          <c:h val="0.46611038316004105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1!$V$170</c:f>
              <c:strCache>
                <c:ptCount val="1"/>
                <c:pt idx="0">
                  <c:v>Control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circle"/>
            <c:size val="7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</c:spPr>
          </c:marker>
          <c:xVal>
            <c:numRef>
              <c:f>Sheet1!$U$171:$U$179</c:f>
              <c:numCache>
                <c:formatCode>0.000</c:formatCode>
                <c:ptCount val="9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45</c:v>
                </c:pt>
                <c:pt idx="4">
                  <c:v>60</c:v>
                </c:pt>
                <c:pt idx="5">
                  <c:v>75</c:v>
                </c:pt>
                <c:pt idx="6">
                  <c:v>90</c:v>
                </c:pt>
                <c:pt idx="7">
                  <c:v>105</c:v>
                </c:pt>
                <c:pt idx="8">
                  <c:v>120</c:v>
                </c:pt>
              </c:numCache>
            </c:numRef>
          </c:xVal>
          <c:yVal>
            <c:numRef>
              <c:f>Sheet1!$V$171:$V$179</c:f>
              <c:numCache>
                <c:formatCode>0.000</c:formatCode>
                <c:ptCount val="9"/>
                <c:pt idx="0">
                  <c:v>1.1233333333333333</c:v>
                </c:pt>
                <c:pt idx="1">
                  <c:v>1.1066666666666667</c:v>
                </c:pt>
                <c:pt idx="2">
                  <c:v>1.0913333333333333</c:v>
                </c:pt>
                <c:pt idx="3">
                  <c:v>1.0696666666666668</c:v>
                </c:pt>
                <c:pt idx="4">
                  <c:v>1.0466666666666666</c:v>
                </c:pt>
                <c:pt idx="5">
                  <c:v>1.0399999999999998</c:v>
                </c:pt>
                <c:pt idx="6">
                  <c:v>1.0323333333333335</c:v>
                </c:pt>
                <c:pt idx="7">
                  <c:v>1.0276666666666667</c:v>
                </c:pt>
                <c:pt idx="8">
                  <c:v>1.0173333333333332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1!$W$170</c:f>
              <c:strCache>
                <c:ptCount val="1"/>
                <c:pt idx="0">
                  <c:v>HL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W$182:$W$190</c:f>
                <c:numCache>
                  <c:formatCode>General</c:formatCode>
                  <c:ptCount val="9"/>
                  <c:pt idx="0">
                    <c:v>3.4372146346197882E-2</c:v>
                  </c:pt>
                  <c:pt idx="1">
                    <c:v>3.9557272122553874E-2</c:v>
                  </c:pt>
                  <c:pt idx="2">
                    <c:v>4.1932485418030421E-2</c:v>
                  </c:pt>
                  <c:pt idx="3">
                    <c:v>2.9356051808405358E-2</c:v>
                  </c:pt>
                  <c:pt idx="4">
                    <c:v>4.1549167661137726E-2</c:v>
                  </c:pt>
                  <c:pt idx="5">
                    <c:v>4.4856561516807225E-2</c:v>
                  </c:pt>
                  <c:pt idx="6">
                    <c:v>4.7188746304365606E-2</c:v>
                  </c:pt>
                  <c:pt idx="7">
                    <c:v>4.7698124817555636E-2</c:v>
                  </c:pt>
                  <c:pt idx="8">
                    <c:v>4.8885353407516527E-2</c:v>
                  </c:pt>
                </c:numCache>
              </c:numRef>
            </c:plus>
            <c:minus>
              <c:numRef>
                <c:f>Sheet1!$W$182:$W$190</c:f>
                <c:numCache>
                  <c:formatCode>General</c:formatCode>
                  <c:ptCount val="9"/>
                  <c:pt idx="0">
                    <c:v>3.4372146346197882E-2</c:v>
                  </c:pt>
                  <c:pt idx="1">
                    <c:v>3.9557272122553874E-2</c:v>
                  </c:pt>
                  <c:pt idx="2">
                    <c:v>4.1932485418030421E-2</c:v>
                  </c:pt>
                  <c:pt idx="3">
                    <c:v>2.9356051808405358E-2</c:v>
                  </c:pt>
                  <c:pt idx="4">
                    <c:v>4.1549167661137726E-2</c:v>
                  </c:pt>
                  <c:pt idx="5">
                    <c:v>4.4856561516807225E-2</c:v>
                  </c:pt>
                  <c:pt idx="6">
                    <c:v>4.7188746304365606E-2</c:v>
                  </c:pt>
                  <c:pt idx="7">
                    <c:v>4.7698124817555636E-2</c:v>
                  </c:pt>
                  <c:pt idx="8">
                    <c:v>4.8885353407516527E-2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1!$U$171:$U$179</c:f>
              <c:numCache>
                <c:formatCode>0.000</c:formatCode>
                <c:ptCount val="9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45</c:v>
                </c:pt>
                <c:pt idx="4">
                  <c:v>60</c:v>
                </c:pt>
                <c:pt idx="5">
                  <c:v>75</c:v>
                </c:pt>
                <c:pt idx="6">
                  <c:v>90</c:v>
                </c:pt>
                <c:pt idx="7">
                  <c:v>105</c:v>
                </c:pt>
                <c:pt idx="8">
                  <c:v>120</c:v>
                </c:pt>
              </c:numCache>
            </c:numRef>
          </c:xVal>
          <c:yVal>
            <c:numRef>
              <c:f>Sheet1!$W$171:$W$179</c:f>
              <c:numCache>
                <c:formatCode>0.000</c:formatCode>
                <c:ptCount val="9"/>
                <c:pt idx="0">
                  <c:v>1.1023333333333334</c:v>
                </c:pt>
                <c:pt idx="1">
                  <c:v>1.0273333333333332</c:v>
                </c:pt>
                <c:pt idx="2">
                  <c:v>0.96200000000000008</c:v>
                </c:pt>
                <c:pt idx="3">
                  <c:v>0.88566666666666671</c:v>
                </c:pt>
                <c:pt idx="4">
                  <c:v>0.80700000000000005</c:v>
                </c:pt>
                <c:pt idx="5">
                  <c:v>0.73966666666666658</c:v>
                </c:pt>
                <c:pt idx="6">
                  <c:v>0.68133333333333324</c:v>
                </c:pt>
                <c:pt idx="7">
                  <c:v>0.62833333333333341</c:v>
                </c:pt>
                <c:pt idx="8">
                  <c:v>0.58233333333333326</c:v>
                </c:pt>
              </c:numCache>
            </c:numRef>
          </c:yVal>
          <c:smooth val="1"/>
        </c:ser>
        <c:ser>
          <c:idx val="4"/>
          <c:order val="2"/>
          <c:tx>
            <c:strRef>
              <c:f>Sheet1!$Z$170</c:f>
              <c:strCache>
                <c:ptCount val="1"/>
                <c:pt idx="0">
                  <c:v>rNm-ACPII + Ab(Lip-II)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circle"/>
            <c:size val="7"/>
            <c:spPr>
              <a:solidFill>
                <a:schemeClr val="bg1">
                  <a:lumMod val="65000"/>
                </a:schemeClr>
              </a:solidFill>
              <a:ln w="12700">
                <a:solidFill>
                  <a:schemeClr val="tx1"/>
                </a:solidFill>
              </a:ln>
            </c:spPr>
          </c:marker>
          <c:xVal>
            <c:numRef>
              <c:f>Sheet1!$U$171:$U$179</c:f>
              <c:numCache>
                <c:formatCode>0.000</c:formatCode>
                <c:ptCount val="9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45</c:v>
                </c:pt>
                <c:pt idx="4">
                  <c:v>60</c:v>
                </c:pt>
                <c:pt idx="5">
                  <c:v>75</c:v>
                </c:pt>
                <c:pt idx="6">
                  <c:v>90</c:v>
                </c:pt>
                <c:pt idx="7">
                  <c:v>105</c:v>
                </c:pt>
                <c:pt idx="8">
                  <c:v>120</c:v>
                </c:pt>
              </c:numCache>
            </c:numRef>
          </c:xVal>
          <c:yVal>
            <c:numRef>
              <c:f>Sheet1!$Z$171:$Z$179</c:f>
              <c:numCache>
                <c:formatCode>0.000</c:formatCode>
                <c:ptCount val="9"/>
                <c:pt idx="0">
                  <c:v>1.1087499999999999</c:v>
                </c:pt>
                <c:pt idx="1">
                  <c:v>1.0952500000000001</c:v>
                </c:pt>
                <c:pt idx="2">
                  <c:v>1.0811666666666666</c:v>
                </c:pt>
                <c:pt idx="3">
                  <c:v>1.0618166666666666</c:v>
                </c:pt>
                <c:pt idx="4">
                  <c:v>1.0505833333333332</c:v>
                </c:pt>
                <c:pt idx="5">
                  <c:v>1.0393333333333332</c:v>
                </c:pt>
                <c:pt idx="6">
                  <c:v>1.0305833333333334</c:v>
                </c:pt>
                <c:pt idx="7">
                  <c:v>1.02125</c:v>
                </c:pt>
                <c:pt idx="8">
                  <c:v>1.0129166666666667</c:v>
                </c:pt>
              </c:numCache>
            </c:numRef>
          </c:yVal>
          <c:smooth val="1"/>
        </c:ser>
        <c:ser>
          <c:idx val="5"/>
          <c:order val="3"/>
          <c:tx>
            <c:strRef>
              <c:f>Sheet1!$AA$170</c:f>
              <c:strCache>
                <c:ptCount val="1"/>
                <c:pt idx="0">
                  <c:v>HL + rNm-ACPII + Ab_cont.Lip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triangle"/>
            <c:size val="7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AA$182:$AA$190</c:f>
                <c:numCache>
                  <c:formatCode>General</c:formatCode>
                  <c:ptCount val="9"/>
                  <c:pt idx="0">
                    <c:v>2.4690319615510218E-2</c:v>
                  </c:pt>
                  <c:pt idx="1">
                    <c:v>2.8458424841238932E-2</c:v>
                  </c:pt>
                  <c:pt idx="2">
                    <c:v>3.0677471425892028E-2</c:v>
                  </c:pt>
                  <c:pt idx="3">
                    <c:v>3.5581455844301786E-2</c:v>
                  </c:pt>
                  <c:pt idx="4">
                    <c:v>3.5753312891479753E-2</c:v>
                  </c:pt>
                  <c:pt idx="5">
                    <c:v>3.7535261199748281E-2</c:v>
                  </c:pt>
                  <c:pt idx="6">
                    <c:v>4.0448870331705362E-2</c:v>
                  </c:pt>
                  <c:pt idx="7">
                    <c:v>4.3152650377096202E-2</c:v>
                  </c:pt>
                  <c:pt idx="8">
                    <c:v>4.801439309670013E-2</c:v>
                  </c:pt>
                </c:numCache>
              </c:numRef>
            </c:plus>
            <c:minus>
              <c:numRef>
                <c:f>Sheet1!$AA$182:$AA$190</c:f>
                <c:numCache>
                  <c:formatCode>General</c:formatCode>
                  <c:ptCount val="9"/>
                  <c:pt idx="0">
                    <c:v>2.4690319615510218E-2</c:v>
                  </c:pt>
                  <c:pt idx="1">
                    <c:v>2.8458424841238932E-2</c:v>
                  </c:pt>
                  <c:pt idx="2">
                    <c:v>3.0677471425892028E-2</c:v>
                  </c:pt>
                  <c:pt idx="3">
                    <c:v>3.5581455844301786E-2</c:v>
                  </c:pt>
                  <c:pt idx="4">
                    <c:v>3.5753312891479753E-2</c:v>
                  </c:pt>
                  <c:pt idx="5">
                    <c:v>3.7535261199748281E-2</c:v>
                  </c:pt>
                  <c:pt idx="6">
                    <c:v>4.0448870331705362E-2</c:v>
                  </c:pt>
                  <c:pt idx="7">
                    <c:v>4.3152650377096202E-2</c:v>
                  </c:pt>
                  <c:pt idx="8">
                    <c:v>4.801439309670013E-2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1!$U$171:$U$179</c:f>
              <c:numCache>
                <c:formatCode>0.000</c:formatCode>
                <c:ptCount val="9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45</c:v>
                </c:pt>
                <c:pt idx="4">
                  <c:v>60</c:v>
                </c:pt>
                <c:pt idx="5">
                  <c:v>75</c:v>
                </c:pt>
                <c:pt idx="6">
                  <c:v>90</c:v>
                </c:pt>
                <c:pt idx="7">
                  <c:v>105</c:v>
                </c:pt>
                <c:pt idx="8">
                  <c:v>120</c:v>
                </c:pt>
              </c:numCache>
            </c:numRef>
          </c:xVal>
          <c:yVal>
            <c:numRef>
              <c:f>Sheet1!$AA$171:$AA$179</c:f>
              <c:numCache>
                <c:formatCode>0.000</c:formatCode>
                <c:ptCount val="9"/>
                <c:pt idx="0">
                  <c:v>1.1099722222222221</c:v>
                </c:pt>
                <c:pt idx="1">
                  <c:v>1.0930833333333332</c:v>
                </c:pt>
                <c:pt idx="2">
                  <c:v>1.0708055555555556</c:v>
                </c:pt>
                <c:pt idx="3">
                  <c:v>1.0517999999999998</c:v>
                </c:pt>
                <c:pt idx="4">
                  <c:v>1.037222222222222</c:v>
                </c:pt>
                <c:pt idx="5">
                  <c:v>1.0242500000000001</c:v>
                </c:pt>
                <c:pt idx="6">
                  <c:v>1.0153333333333334</c:v>
                </c:pt>
                <c:pt idx="7">
                  <c:v>1.0078888888888888</c:v>
                </c:pt>
                <c:pt idx="8">
                  <c:v>1.0064166666666667</c:v>
                </c:pt>
              </c:numCache>
            </c:numRef>
          </c:yVal>
          <c:smooth val="1"/>
        </c:ser>
        <c:ser>
          <c:idx val="6"/>
          <c:order val="4"/>
          <c:tx>
            <c:strRef>
              <c:f>Sheet1!$AB$170</c:f>
              <c:strCache>
                <c:ptCount val="1"/>
                <c:pt idx="0">
                  <c:v>rNm-ACPII + Ab_cont.Lip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triangle"/>
            <c:size val="7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</c:spPr>
          </c:marker>
          <c:xVal>
            <c:numRef>
              <c:f>Sheet1!$U$171:$U$179</c:f>
              <c:numCache>
                <c:formatCode>0.000</c:formatCode>
                <c:ptCount val="9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45</c:v>
                </c:pt>
                <c:pt idx="4">
                  <c:v>60</c:v>
                </c:pt>
                <c:pt idx="5">
                  <c:v>75</c:v>
                </c:pt>
                <c:pt idx="6">
                  <c:v>90</c:v>
                </c:pt>
                <c:pt idx="7">
                  <c:v>105</c:v>
                </c:pt>
                <c:pt idx="8">
                  <c:v>120</c:v>
                </c:pt>
              </c:numCache>
            </c:numRef>
          </c:xVal>
          <c:yVal>
            <c:numRef>
              <c:f>Sheet1!$AB$171:$AB$179</c:f>
              <c:numCache>
                <c:formatCode>0.000</c:formatCode>
                <c:ptCount val="9"/>
                <c:pt idx="0">
                  <c:v>1.1398453703703701</c:v>
                </c:pt>
                <c:pt idx="1">
                  <c:v>1.110602777777778</c:v>
                </c:pt>
                <c:pt idx="2">
                  <c:v>1.0871997685185186</c:v>
                </c:pt>
                <c:pt idx="3">
                  <c:v>1.0743618055555555</c:v>
                </c:pt>
                <c:pt idx="4">
                  <c:v>1.0571891203703705</c:v>
                </c:pt>
                <c:pt idx="5">
                  <c:v>1.0453960648148148</c:v>
                </c:pt>
                <c:pt idx="6">
                  <c:v>1.0344613425925926</c:v>
                </c:pt>
                <c:pt idx="7">
                  <c:v>1.0255488425925925</c:v>
                </c:pt>
                <c:pt idx="8">
                  <c:v>1.019693287037037</c:v>
                </c:pt>
              </c:numCache>
            </c:numRef>
          </c:yVal>
          <c:smooth val="1"/>
        </c:ser>
        <c:ser>
          <c:idx val="8"/>
          <c:order val="5"/>
          <c:tx>
            <c:strRef>
              <c:f>Sheet1!$AD$170</c:f>
              <c:strCache>
                <c:ptCount val="1"/>
                <c:pt idx="0">
                  <c:v>rNm-ACPII + Ab(Sal-II)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triangle"/>
            <c:size val="7"/>
            <c:spPr>
              <a:solidFill>
                <a:schemeClr val="bg1">
                  <a:lumMod val="65000"/>
                </a:schemeClr>
              </a:solidFill>
              <a:ln w="1270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AD$182:$AD$190</c:f>
                <c:numCache>
                  <c:formatCode>General</c:formatCode>
                  <c:ptCount val="9"/>
                  <c:pt idx="0">
                    <c:v>3.2716268925422273E-3</c:v>
                  </c:pt>
                  <c:pt idx="1">
                    <c:v>8.3309834649834564E-3</c:v>
                  </c:pt>
                  <c:pt idx="2">
                    <c:v>1.2468667039838014E-2</c:v>
                  </c:pt>
                  <c:pt idx="3">
                    <c:v>1.2834160627495138E-2</c:v>
                  </c:pt>
                  <c:pt idx="4">
                    <c:v>1.4455856721509546E-2</c:v>
                  </c:pt>
                  <c:pt idx="5">
                    <c:v>1.6719440624236831E-2</c:v>
                  </c:pt>
                  <c:pt idx="6">
                    <c:v>1.7827316708409799E-2</c:v>
                  </c:pt>
                  <c:pt idx="7">
                    <c:v>1.8470929593685036E-2</c:v>
                  </c:pt>
                  <c:pt idx="8">
                    <c:v>2.0451856882234703E-2</c:v>
                  </c:pt>
                </c:numCache>
              </c:numRef>
            </c:plus>
            <c:minus>
              <c:numRef>
                <c:f>Sheet1!$AD$182:$AD$190</c:f>
                <c:numCache>
                  <c:formatCode>General</c:formatCode>
                  <c:ptCount val="9"/>
                  <c:pt idx="0">
                    <c:v>3.2716268925422273E-3</c:v>
                  </c:pt>
                  <c:pt idx="1">
                    <c:v>8.3309834649834564E-3</c:v>
                  </c:pt>
                  <c:pt idx="2">
                    <c:v>1.2468667039838014E-2</c:v>
                  </c:pt>
                  <c:pt idx="3">
                    <c:v>1.2834160627495138E-2</c:v>
                  </c:pt>
                  <c:pt idx="4">
                    <c:v>1.4455856721509546E-2</c:v>
                  </c:pt>
                  <c:pt idx="5">
                    <c:v>1.6719440624236831E-2</c:v>
                  </c:pt>
                  <c:pt idx="6">
                    <c:v>1.7827316708409799E-2</c:v>
                  </c:pt>
                  <c:pt idx="7">
                    <c:v>1.8470929593685036E-2</c:v>
                  </c:pt>
                  <c:pt idx="8">
                    <c:v>2.0451856882234703E-2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1!$U$171:$U$179</c:f>
              <c:numCache>
                <c:formatCode>0.000</c:formatCode>
                <c:ptCount val="9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45</c:v>
                </c:pt>
                <c:pt idx="4">
                  <c:v>60</c:v>
                </c:pt>
                <c:pt idx="5">
                  <c:v>75</c:v>
                </c:pt>
                <c:pt idx="6">
                  <c:v>90</c:v>
                </c:pt>
                <c:pt idx="7">
                  <c:v>105</c:v>
                </c:pt>
                <c:pt idx="8">
                  <c:v>120</c:v>
                </c:pt>
              </c:numCache>
            </c:numRef>
          </c:xVal>
          <c:yVal>
            <c:numRef>
              <c:f>Sheet1!$AD$171:$AD$179</c:f>
              <c:numCache>
                <c:formatCode>0.000</c:formatCode>
                <c:ptCount val="9"/>
                <c:pt idx="0">
                  <c:v>1.1382092592592592</c:v>
                </c:pt>
                <c:pt idx="1">
                  <c:v>1.1166527777777777</c:v>
                </c:pt>
                <c:pt idx="2">
                  <c:v>1.0955685185185187</c:v>
                </c:pt>
                <c:pt idx="3">
                  <c:v>1.0824777777777779</c:v>
                </c:pt>
                <c:pt idx="4">
                  <c:v>1.0662314814814815</c:v>
                </c:pt>
                <c:pt idx="5">
                  <c:v>1.0537314814814815</c:v>
                </c:pt>
                <c:pt idx="6">
                  <c:v>1.0445564814814814</c:v>
                </c:pt>
                <c:pt idx="7">
                  <c:v>1.0365925925925925</c:v>
                </c:pt>
                <c:pt idx="8">
                  <c:v>1.0328592592592594</c:v>
                </c:pt>
              </c:numCache>
            </c:numRef>
          </c:yVal>
          <c:smooth val="1"/>
        </c:ser>
        <c:ser>
          <c:idx val="9"/>
          <c:order val="6"/>
          <c:tx>
            <c:strRef>
              <c:f>Sheet1!$AE$170</c:f>
              <c:strCache>
                <c:ptCount val="1"/>
                <c:pt idx="0">
                  <c:v>HL + rNm-ACPII + Ab_cont.Sal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square"/>
            <c:size val="7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AE$182:$AE$190</c:f>
                <c:numCache>
                  <c:formatCode>General</c:formatCode>
                  <c:ptCount val="9"/>
                  <c:pt idx="0">
                    <c:v>5.5320997040282389E-3</c:v>
                  </c:pt>
                  <c:pt idx="1">
                    <c:v>5.8615656101664365E-3</c:v>
                  </c:pt>
                  <c:pt idx="2">
                    <c:v>3.6489924038569936E-3</c:v>
                  </c:pt>
                  <c:pt idx="3">
                    <c:v>4.8231966559313284E-3</c:v>
                  </c:pt>
                  <c:pt idx="4">
                    <c:v>5.2687996403068382E-3</c:v>
                  </c:pt>
                  <c:pt idx="5">
                    <c:v>4.8278722827109445E-3</c:v>
                  </c:pt>
                  <c:pt idx="6">
                    <c:v>4.2612628676233369E-3</c:v>
                  </c:pt>
                  <c:pt idx="7">
                    <c:v>3.79557688928295E-3</c:v>
                  </c:pt>
                  <c:pt idx="8">
                    <c:v>3.7906289849801806E-3</c:v>
                  </c:pt>
                </c:numCache>
              </c:numRef>
            </c:plus>
            <c:minus>
              <c:numRef>
                <c:f>Sheet1!$AE$182:$AE$190</c:f>
                <c:numCache>
                  <c:formatCode>General</c:formatCode>
                  <c:ptCount val="9"/>
                  <c:pt idx="0">
                    <c:v>5.5320997040282389E-3</c:v>
                  </c:pt>
                  <c:pt idx="1">
                    <c:v>5.8615656101664365E-3</c:v>
                  </c:pt>
                  <c:pt idx="2">
                    <c:v>3.6489924038569936E-3</c:v>
                  </c:pt>
                  <c:pt idx="3">
                    <c:v>4.8231966559313284E-3</c:v>
                  </c:pt>
                  <c:pt idx="4">
                    <c:v>5.2687996403068382E-3</c:v>
                  </c:pt>
                  <c:pt idx="5">
                    <c:v>4.8278722827109445E-3</c:v>
                  </c:pt>
                  <c:pt idx="6">
                    <c:v>4.2612628676233369E-3</c:v>
                  </c:pt>
                  <c:pt idx="7">
                    <c:v>3.79557688928295E-3</c:v>
                  </c:pt>
                  <c:pt idx="8">
                    <c:v>3.7906289849801806E-3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1!$U$171:$U$179</c:f>
              <c:numCache>
                <c:formatCode>0.000</c:formatCode>
                <c:ptCount val="9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45</c:v>
                </c:pt>
                <c:pt idx="4">
                  <c:v>60</c:v>
                </c:pt>
                <c:pt idx="5">
                  <c:v>75</c:v>
                </c:pt>
                <c:pt idx="6">
                  <c:v>90</c:v>
                </c:pt>
                <c:pt idx="7">
                  <c:v>105</c:v>
                </c:pt>
                <c:pt idx="8">
                  <c:v>120</c:v>
                </c:pt>
              </c:numCache>
            </c:numRef>
          </c:xVal>
          <c:yVal>
            <c:numRef>
              <c:f>Sheet1!$AE$171:$AE$179</c:f>
              <c:numCache>
                <c:formatCode>0.000</c:formatCode>
                <c:ptCount val="9"/>
                <c:pt idx="0">
                  <c:v>1.1286450231481482</c:v>
                </c:pt>
                <c:pt idx="1">
                  <c:v>1.1039186342592591</c:v>
                </c:pt>
                <c:pt idx="2">
                  <c:v>1.0834183449074073</c:v>
                </c:pt>
                <c:pt idx="3">
                  <c:v>1.0723001736111111</c:v>
                </c:pt>
                <c:pt idx="4">
                  <c:v>1.0516236689814813</c:v>
                </c:pt>
                <c:pt idx="5">
                  <c:v>1.0367336226851853</c:v>
                </c:pt>
                <c:pt idx="6">
                  <c:v>1.0253516782407408</c:v>
                </c:pt>
                <c:pt idx="7">
                  <c:v>1.0152575810185187</c:v>
                </c:pt>
                <c:pt idx="8">
                  <c:v>1.0084869791666666</c:v>
                </c:pt>
              </c:numCache>
            </c:numRef>
          </c:yVal>
          <c:smooth val="1"/>
        </c:ser>
        <c:ser>
          <c:idx val="10"/>
          <c:order val="7"/>
          <c:tx>
            <c:strRef>
              <c:f>Sheet1!$AF$170</c:f>
              <c:strCache>
                <c:ptCount val="1"/>
                <c:pt idx="0">
                  <c:v>rNm-ACPII + Ab_cont.Sal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square"/>
            <c:size val="7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AF$182:$AF$190</c:f>
                <c:numCache>
                  <c:formatCode>General</c:formatCode>
                  <c:ptCount val="9"/>
                  <c:pt idx="0">
                    <c:v>2.2417131345865367E-2</c:v>
                  </c:pt>
                  <c:pt idx="1">
                    <c:v>1.2489995996796807E-2</c:v>
                  </c:pt>
                  <c:pt idx="2">
                    <c:v>9.4442810443381309E-3</c:v>
                  </c:pt>
                  <c:pt idx="3">
                    <c:v>1.2949688970953907E-2</c:v>
                  </c:pt>
                  <c:pt idx="4">
                    <c:v>1.4844565036103614E-2</c:v>
                  </c:pt>
                  <c:pt idx="5">
                    <c:v>1.8744628860319169E-2</c:v>
                  </c:pt>
                  <c:pt idx="6">
                    <c:v>1.9500000000000035E-2</c:v>
                  </c:pt>
                  <c:pt idx="7">
                    <c:v>1.9417203139942045E-2</c:v>
                  </c:pt>
                  <c:pt idx="8">
                    <c:v>1.9626371148137537E-2</c:v>
                  </c:pt>
                </c:numCache>
              </c:numRef>
            </c:plus>
            <c:minus>
              <c:numRef>
                <c:f>Sheet1!$AF$182:$AF$190</c:f>
                <c:numCache>
                  <c:formatCode>General</c:formatCode>
                  <c:ptCount val="9"/>
                  <c:pt idx="0">
                    <c:v>2.2417131345865367E-2</c:v>
                  </c:pt>
                  <c:pt idx="1">
                    <c:v>1.2489995996796807E-2</c:v>
                  </c:pt>
                  <c:pt idx="2">
                    <c:v>9.4442810443381309E-3</c:v>
                  </c:pt>
                  <c:pt idx="3">
                    <c:v>1.2949688970953907E-2</c:v>
                  </c:pt>
                  <c:pt idx="4">
                    <c:v>1.4844565036103614E-2</c:v>
                  </c:pt>
                  <c:pt idx="5">
                    <c:v>1.8744628860319169E-2</c:v>
                  </c:pt>
                  <c:pt idx="6">
                    <c:v>1.9500000000000035E-2</c:v>
                  </c:pt>
                  <c:pt idx="7">
                    <c:v>1.9417203139942045E-2</c:v>
                  </c:pt>
                  <c:pt idx="8">
                    <c:v>1.9626371148137537E-2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1!$U$171:$U$179</c:f>
              <c:numCache>
                <c:formatCode>0.000</c:formatCode>
                <c:ptCount val="9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45</c:v>
                </c:pt>
                <c:pt idx="4">
                  <c:v>60</c:v>
                </c:pt>
                <c:pt idx="5">
                  <c:v>75</c:v>
                </c:pt>
                <c:pt idx="6">
                  <c:v>90</c:v>
                </c:pt>
                <c:pt idx="7">
                  <c:v>105</c:v>
                </c:pt>
                <c:pt idx="8">
                  <c:v>120</c:v>
                </c:pt>
              </c:numCache>
            </c:numRef>
          </c:xVal>
          <c:yVal>
            <c:numRef>
              <c:f>Sheet1!$AF$171:$AF$179</c:f>
              <c:numCache>
                <c:formatCode>0.000</c:formatCode>
                <c:ptCount val="9"/>
                <c:pt idx="0">
                  <c:v>1.1236666666666666</c:v>
                </c:pt>
                <c:pt idx="1">
                  <c:v>1.1125</c:v>
                </c:pt>
                <c:pt idx="2">
                  <c:v>1.0918333333333334</c:v>
                </c:pt>
                <c:pt idx="3">
                  <c:v>1.0746666666666667</c:v>
                </c:pt>
                <c:pt idx="4">
                  <c:v>1.0556666666666665</c:v>
                </c:pt>
                <c:pt idx="5">
                  <c:v>1.0456666666666667</c:v>
                </c:pt>
                <c:pt idx="6">
                  <c:v>1.0354999999999999</c:v>
                </c:pt>
                <c:pt idx="7">
                  <c:v>1.0253333333333332</c:v>
                </c:pt>
                <c:pt idx="8">
                  <c:v>1.0203333333333333</c:v>
                </c:pt>
              </c:numCache>
            </c:numRef>
          </c:yVal>
          <c:smooth val="1"/>
        </c:ser>
        <c:ser>
          <c:idx val="12"/>
          <c:order val="8"/>
          <c:tx>
            <c:strRef>
              <c:f>Sheet1!$AH$170</c:f>
              <c:strCache>
                <c:ptCount val="1"/>
                <c:pt idx="0">
                  <c:v>rNm-ACPII + Ab(Al-II)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square"/>
            <c:size val="7"/>
            <c:spPr>
              <a:solidFill>
                <a:schemeClr val="bg1">
                  <a:lumMod val="65000"/>
                </a:schemeClr>
              </a:solidFill>
              <a:ln w="1270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AH$182:$AH$190</c:f>
                <c:numCache>
                  <c:formatCode>General</c:formatCode>
                  <c:ptCount val="9"/>
                  <c:pt idx="0">
                    <c:v>3.0339483566297026E-3</c:v>
                  </c:pt>
                  <c:pt idx="1">
                    <c:v>5.0584630765524961E-3</c:v>
                  </c:pt>
                  <c:pt idx="2">
                    <c:v>7.8420145508258151E-3</c:v>
                  </c:pt>
                  <c:pt idx="3">
                    <c:v>8.711318318909974E-3</c:v>
                  </c:pt>
                  <c:pt idx="4">
                    <c:v>1.6215397088794863E-2</c:v>
                  </c:pt>
                  <c:pt idx="5">
                    <c:v>2.2196212112274034E-2</c:v>
                  </c:pt>
                  <c:pt idx="6">
                    <c:v>2.3724068992679728E-2</c:v>
                  </c:pt>
                  <c:pt idx="7">
                    <c:v>2.4818610216243833E-2</c:v>
                  </c:pt>
                  <c:pt idx="8">
                    <c:v>2.1439837030449715E-2</c:v>
                  </c:pt>
                </c:numCache>
              </c:numRef>
            </c:plus>
            <c:minus>
              <c:numRef>
                <c:f>Sheet1!$AH$182:$AH$190</c:f>
                <c:numCache>
                  <c:formatCode>General</c:formatCode>
                  <c:ptCount val="9"/>
                  <c:pt idx="0">
                    <c:v>3.0339483566297026E-3</c:v>
                  </c:pt>
                  <c:pt idx="1">
                    <c:v>5.0584630765524961E-3</c:v>
                  </c:pt>
                  <c:pt idx="2">
                    <c:v>7.8420145508258151E-3</c:v>
                  </c:pt>
                  <c:pt idx="3">
                    <c:v>8.711318318909974E-3</c:v>
                  </c:pt>
                  <c:pt idx="4">
                    <c:v>1.6215397088794863E-2</c:v>
                  </c:pt>
                  <c:pt idx="5">
                    <c:v>2.2196212112274034E-2</c:v>
                  </c:pt>
                  <c:pt idx="6">
                    <c:v>2.3724068992679728E-2</c:v>
                  </c:pt>
                  <c:pt idx="7">
                    <c:v>2.4818610216243833E-2</c:v>
                  </c:pt>
                  <c:pt idx="8">
                    <c:v>2.1439837030449715E-2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1!$U$171:$U$179</c:f>
              <c:numCache>
                <c:formatCode>0.000</c:formatCode>
                <c:ptCount val="9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45</c:v>
                </c:pt>
                <c:pt idx="4">
                  <c:v>60</c:v>
                </c:pt>
                <c:pt idx="5">
                  <c:v>75</c:v>
                </c:pt>
                <c:pt idx="6">
                  <c:v>90</c:v>
                </c:pt>
                <c:pt idx="7">
                  <c:v>105</c:v>
                </c:pt>
                <c:pt idx="8">
                  <c:v>120</c:v>
                </c:pt>
              </c:numCache>
            </c:numRef>
          </c:xVal>
          <c:yVal>
            <c:numRef>
              <c:f>Sheet1!$AH$171:$AH$179</c:f>
              <c:numCache>
                <c:formatCode>0.000</c:formatCode>
                <c:ptCount val="9"/>
                <c:pt idx="0">
                  <c:v>1.1398783950617284</c:v>
                </c:pt>
                <c:pt idx="1">
                  <c:v>1.1196574074074075</c:v>
                </c:pt>
                <c:pt idx="2">
                  <c:v>1.1081898148148148</c:v>
                </c:pt>
                <c:pt idx="3">
                  <c:v>1.1005237654320987</c:v>
                </c:pt>
                <c:pt idx="4">
                  <c:v>1.094229938271605</c:v>
                </c:pt>
                <c:pt idx="5">
                  <c:v>1.0903379629629628</c:v>
                </c:pt>
                <c:pt idx="6">
                  <c:v>1.0842793209876544</c:v>
                </c:pt>
                <c:pt idx="7">
                  <c:v>1.0783472222222221</c:v>
                </c:pt>
                <c:pt idx="8">
                  <c:v>1.0703441358024692</c:v>
                </c:pt>
              </c:numCache>
            </c:numRef>
          </c:yVal>
          <c:smooth val="1"/>
        </c:ser>
        <c:ser>
          <c:idx val="13"/>
          <c:order val="9"/>
          <c:tx>
            <c:strRef>
              <c:f>Sheet1!$AI$170</c:f>
              <c:strCache>
                <c:ptCount val="1"/>
                <c:pt idx="0">
                  <c:v>HL + rNm-ACPII + Ab_cont.Al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diamond"/>
            <c:size val="7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AI$182:$AI$190</c:f>
                <c:numCache>
                  <c:formatCode>General</c:formatCode>
                  <c:ptCount val="9"/>
                  <c:pt idx="0">
                    <c:v>2.4492268490315934E-3</c:v>
                  </c:pt>
                  <c:pt idx="1">
                    <c:v>1.162108385554937E-2</c:v>
                  </c:pt>
                  <c:pt idx="2">
                    <c:v>1.75927040101315E-2</c:v>
                  </c:pt>
                  <c:pt idx="3">
                    <c:v>2.0016816161888305E-2</c:v>
                  </c:pt>
                  <c:pt idx="4">
                    <c:v>2.1145918878821997E-2</c:v>
                  </c:pt>
                  <c:pt idx="5">
                    <c:v>2.485432861634022E-2</c:v>
                  </c:pt>
                  <c:pt idx="6">
                    <c:v>2.8444643233223398E-2</c:v>
                  </c:pt>
                  <c:pt idx="7">
                    <c:v>3.2242876339945548E-2</c:v>
                  </c:pt>
                  <c:pt idx="8">
                    <c:v>3.7398696152310444E-2</c:v>
                  </c:pt>
                </c:numCache>
              </c:numRef>
            </c:plus>
            <c:minus>
              <c:numRef>
                <c:f>Sheet1!$AI$182:$AI$190</c:f>
                <c:numCache>
                  <c:formatCode>General</c:formatCode>
                  <c:ptCount val="9"/>
                  <c:pt idx="0">
                    <c:v>2.4492268490315934E-3</c:v>
                  </c:pt>
                  <c:pt idx="1">
                    <c:v>1.162108385554937E-2</c:v>
                  </c:pt>
                  <c:pt idx="2">
                    <c:v>1.75927040101315E-2</c:v>
                  </c:pt>
                  <c:pt idx="3">
                    <c:v>2.0016816161888305E-2</c:v>
                  </c:pt>
                  <c:pt idx="4">
                    <c:v>2.1145918878821997E-2</c:v>
                  </c:pt>
                  <c:pt idx="5">
                    <c:v>2.485432861634022E-2</c:v>
                  </c:pt>
                  <c:pt idx="6">
                    <c:v>2.8444643233223398E-2</c:v>
                  </c:pt>
                  <c:pt idx="7">
                    <c:v>3.2242876339945548E-2</c:v>
                  </c:pt>
                  <c:pt idx="8">
                    <c:v>3.7398696152310444E-2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1!$U$171:$U$179</c:f>
              <c:numCache>
                <c:formatCode>0.000</c:formatCode>
                <c:ptCount val="9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45</c:v>
                </c:pt>
                <c:pt idx="4">
                  <c:v>60</c:v>
                </c:pt>
                <c:pt idx="5">
                  <c:v>75</c:v>
                </c:pt>
                <c:pt idx="6">
                  <c:v>90</c:v>
                </c:pt>
                <c:pt idx="7">
                  <c:v>105</c:v>
                </c:pt>
                <c:pt idx="8">
                  <c:v>120</c:v>
                </c:pt>
              </c:numCache>
            </c:numRef>
          </c:xVal>
          <c:yVal>
            <c:numRef>
              <c:f>Sheet1!$AI$171:$AI$179</c:f>
              <c:numCache>
                <c:formatCode>0.000</c:formatCode>
                <c:ptCount val="9"/>
                <c:pt idx="0">
                  <c:v>1.1372711419753085</c:v>
                </c:pt>
                <c:pt idx="1">
                  <c:v>1.1192365740740742</c:v>
                </c:pt>
                <c:pt idx="2">
                  <c:v>1.1003612654320987</c:v>
                </c:pt>
                <c:pt idx="3">
                  <c:v>1.0779351851851853</c:v>
                </c:pt>
                <c:pt idx="4">
                  <c:v>1.0589604938271606</c:v>
                </c:pt>
                <c:pt idx="5">
                  <c:v>1.047641512345679</c:v>
                </c:pt>
                <c:pt idx="6">
                  <c:v>1.0368929012345678</c:v>
                </c:pt>
                <c:pt idx="7">
                  <c:v>1.0262641975308642</c:v>
                </c:pt>
                <c:pt idx="8">
                  <c:v>1.0178503086419752</c:v>
                </c:pt>
              </c:numCache>
            </c:numRef>
          </c:yVal>
          <c:smooth val="1"/>
        </c:ser>
        <c:ser>
          <c:idx val="14"/>
          <c:order val="10"/>
          <c:tx>
            <c:strRef>
              <c:f>Sheet1!$AJ$170</c:f>
              <c:strCache>
                <c:ptCount val="1"/>
                <c:pt idx="0">
                  <c:v>rNm-ACPII + Ab_cont.Al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diamond"/>
            <c:size val="7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AJ$182:$AJ$190</c:f>
                <c:numCache>
                  <c:formatCode>General</c:formatCode>
                  <c:ptCount val="9"/>
                  <c:pt idx="0">
                    <c:v>9.5759878513990496E-3</c:v>
                  </c:pt>
                  <c:pt idx="1">
                    <c:v>1.4824867832969175E-2</c:v>
                  </c:pt>
                  <c:pt idx="2">
                    <c:v>2.2074961698788913E-2</c:v>
                  </c:pt>
                  <c:pt idx="3">
                    <c:v>2.4152011780746968E-2</c:v>
                  </c:pt>
                  <c:pt idx="4">
                    <c:v>2.3252491482829048E-2</c:v>
                  </c:pt>
                  <c:pt idx="5">
                    <c:v>2.4225237929086353E-2</c:v>
                  </c:pt>
                  <c:pt idx="6">
                    <c:v>2.4622725085040764E-2</c:v>
                  </c:pt>
                  <c:pt idx="7">
                    <c:v>2.6098182186119707E-2</c:v>
                  </c:pt>
                  <c:pt idx="8">
                    <c:v>2.9578183376019106E-2</c:v>
                  </c:pt>
                </c:numCache>
              </c:numRef>
            </c:plus>
            <c:minus>
              <c:numRef>
                <c:f>Sheet1!$AJ$182:$AJ$190</c:f>
                <c:numCache>
                  <c:formatCode>General</c:formatCode>
                  <c:ptCount val="9"/>
                  <c:pt idx="0">
                    <c:v>9.5759878513990496E-3</c:v>
                  </c:pt>
                  <c:pt idx="1">
                    <c:v>1.4824867832969175E-2</c:v>
                  </c:pt>
                  <c:pt idx="2">
                    <c:v>2.2074961698788913E-2</c:v>
                  </c:pt>
                  <c:pt idx="3">
                    <c:v>2.4152011780746968E-2</c:v>
                  </c:pt>
                  <c:pt idx="4">
                    <c:v>2.3252491482829048E-2</c:v>
                  </c:pt>
                  <c:pt idx="5">
                    <c:v>2.4225237929086353E-2</c:v>
                  </c:pt>
                  <c:pt idx="6">
                    <c:v>2.4622725085040764E-2</c:v>
                  </c:pt>
                  <c:pt idx="7">
                    <c:v>2.6098182186119707E-2</c:v>
                  </c:pt>
                  <c:pt idx="8">
                    <c:v>2.9578183376019106E-2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1!$U$171:$U$179</c:f>
              <c:numCache>
                <c:formatCode>0.000</c:formatCode>
                <c:ptCount val="9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45</c:v>
                </c:pt>
                <c:pt idx="4">
                  <c:v>60</c:v>
                </c:pt>
                <c:pt idx="5">
                  <c:v>75</c:v>
                </c:pt>
                <c:pt idx="6">
                  <c:v>90</c:v>
                </c:pt>
                <c:pt idx="7">
                  <c:v>105</c:v>
                </c:pt>
                <c:pt idx="8">
                  <c:v>120</c:v>
                </c:pt>
              </c:numCache>
            </c:numRef>
          </c:xVal>
          <c:yVal>
            <c:numRef>
              <c:f>Sheet1!$AJ$171:$AJ$179</c:f>
              <c:numCache>
                <c:formatCode>0.000</c:formatCode>
                <c:ptCount val="9"/>
                <c:pt idx="0">
                  <c:v>1.1253084876543209</c:v>
                </c:pt>
                <c:pt idx="1">
                  <c:v>1.1242518518518518</c:v>
                </c:pt>
                <c:pt idx="2">
                  <c:v>1.1133257523148148</c:v>
                </c:pt>
                <c:pt idx="3">
                  <c:v>1.0941147955246913</c:v>
                </c:pt>
                <c:pt idx="4">
                  <c:v>1.0766646026234568</c:v>
                </c:pt>
                <c:pt idx="5">
                  <c:v>1.0686072337962962</c:v>
                </c:pt>
                <c:pt idx="6">
                  <c:v>1.0608602816358026</c:v>
                </c:pt>
                <c:pt idx="7">
                  <c:v>1.0528387152777778</c:v>
                </c:pt>
                <c:pt idx="8">
                  <c:v>1.0472587770061728</c:v>
                </c:pt>
              </c:numCache>
            </c:numRef>
          </c:yVal>
          <c:smooth val="1"/>
        </c:ser>
        <c:ser>
          <c:idx val="16"/>
          <c:order val="11"/>
          <c:tx>
            <c:strRef>
              <c:f>Sheet1!$AL$170</c:f>
              <c:strCache>
                <c:ptCount val="1"/>
                <c:pt idx="0">
                  <c:v>rNm-ACPII + NMS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diamond"/>
            <c:size val="7"/>
            <c:spPr>
              <a:solidFill>
                <a:schemeClr val="bg1">
                  <a:lumMod val="65000"/>
                </a:schemeClr>
              </a:solidFill>
              <a:ln w="1270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AL$182:$AL$190</c:f>
                <c:numCache>
                  <c:formatCode>General</c:formatCode>
                  <c:ptCount val="9"/>
                  <c:pt idx="0">
                    <c:v>5.429663735934457E-3</c:v>
                  </c:pt>
                  <c:pt idx="1">
                    <c:v>5.6890444133834176E-3</c:v>
                  </c:pt>
                  <c:pt idx="2">
                    <c:v>8.4129635744041621E-3</c:v>
                  </c:pt>
                  <c:pt idx="3">
                    <c:v>7.9892013881427432E-3</c:v>
                  </c:pt>
                  <c:pt idx="4">
                    <c:v>9.5425370692191168E-3</c:v>
                  </c:pt>
                  <c:pt idx="5">
                    <c:v>9.1795405296073787E-3</c:v>
                  </c:pt>
                  <c:pt idx="6">
                    <c:v>8.0687996703793612E-3</c:v>
                  </c:pt>
                  <c:pt idx="7">
                    <c:v>5.5199786783150387E-3</c:v>
                  </c:pt>
                  <c:pt idx="8">
                    <c:v>4.6364024533242136E-3</c:v>
                  </c:pt>
                </c:numCache>
              </c:numRef>
            </c:plus>
            <c:minus>
              <c:numRef>
                <c:f>Sheet1!$AL$182:$AL$190</c:f>
                <c:numCache>
                  <c:formatCode>General</c:formatCode>
                  <c:ptCount val="9"/>
                  <c:pt idx="0">
                    <c:v>5.429663735934457E-3</c:v>
                  </c:pt>
                  <c:pt idx="1">
                    <c:v>5.6890444133834176E-3</c:v>
                  </c:pt>
                  <c:pt idx="2">
                    <c:v>8.4129635744041621E-3</c:v>
                  </c:pt>
                  <c:pt idx="3">
                    <c:v>7.9892013881427432E-3</c:v>
                  </c:pt>
                  <c:pt idx="4">
                    <c:v>9.5425370692191168E-3</c:v>
                  </c:pt>
                  <c:pt idx="5">
                    <c:v>9.1795405296073787E-3</c:v>
                  </c:pt>
                  <c:pt idx="6">
                    <c:v>8.0687996703793612E-3</c:v>
                  </c:pt>
                  <c:pt idx="7">
                    <c:v>5.5199786783150387E-3</c:v>
                  </c:pt>
                  <c:pt idx="8">
                    <c:v>4.6364024533242136E-3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1!$U$171:$U$179</c:f>
              <c:numCache>
                <c:formatCode>0.000</c:formatCode>
                <c:ptCount val="9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45</c:v>
                </c:pt>
                <c:pt idx="4">
                  <c:v>60</c:v>
                </c:pt>
                <c:pt idx="5">
                  <c:v>75</c:v>
                </c:pt>
                <c:pt idx="6">
                  <c:v>90</c:v>
                </c:pt>
                <c:pt idx="7">
                  <c:v>105</c:v>
                </c:pt>
                <c:pt idx="8">
                  <c:v>120</c:v>
                </c:pt>
              </c:numCache>
            </c:numRef>
          </c:xVal>
          <c:yVal>
            <c:numRef>
              <c:f>Sheet1!$AL$171:$AL$179</c:f>
              <c:numCache>
                <c:formatCode>0.000</c:formatCode>
                <c:ptCount val="9"/>
                <c:pt idx="0">
                  <c:v>1.1429740740740744</c:v>
                </c:pt>
                <c:pt idx="1">
                  <c:v>1.1154999999999999</c:v>
                </c:pt>
                <c:pt idx="2">
                  <c:v>1.0849518518518517</c:v>
                </c:pt>
                <c:pt idx="3">
                  <c:v>1.0633074074074074</c:v>
                </c:pt>
                <c:pt idx="4">
                  <c:v>1.0412037037037036</c:v>
                </c:pt>
                <c:pt idx="5">
                  <c:v>1.0235074074074075</c:v>
                </c:pt>
                <c:pt idx="6">
                  <c:v>1.0100851851851853</c:v>
                </c:pt>
                <c:pt idx="7">
                  <c:v>0.99827777777777771</c:v>
                </c:pt>
                <c:pt idx="8">
                  <c:v>0.98831481481481498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2075648"/>
        <c:axId val="212077568"/>
      </c:scatterChart>
      <c:valAx>
        <c:axId val="212075648"/>
        <c:scaling>
          <c:orientation val="minMax"/>
          <c:max val="13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sz="12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200">
                    <a:latin typeface="Arial" panose="020B0604020202020204" pitchFamily="34" charset="0"/>
                    <a:cs typeface="Arial" panose="020B0604020202020204" pitchFamily="34" charset="0"/>
                  </a:rPr>
                  <a:t>Time (min)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12077568"/>
        <c:crosses val="autoZero"/>
        <c:crossBetween val="midCat"/>
        <c:majorUnit val="15"/>
      </c:valAx>
      <c:valAx>
        <c:axId val="212077568"/>
        <c:scaling>
          <c:orientation val="minMax"/>
          <c:max val="1.2"/>
          <c:min val="0.4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200" b="1" i="0" u="none" strike="noStrike" baseline="0" dirty="0" smtClean="0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Abs (</a:t>
                </a:r>
                <a:r>
                  <a:rPr lang="el-GR" sz="1200" b="1" i="0" u="none" strike="noStrike" baseline="0" dirty="0" smtClean="0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λ</a:t>
                </a:r>
                <a:r>
                  <a:rPr lang="en-GB" sz="1200" b="1" i="0" u="none" strike="noStrike" baseline="0" dirty="0" smtClean="0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 = 595 nm)</a:t>
                </a:r>
                <a:endParaRPr lang="en-US" sz="1200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</c:title>
        <c:numFmt formatCode="0.0" sourceLinked="0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12075648"/>
        <c:crosses val="autoZero"/>
        <c:crossBetween val="midCat"/>
        <c:majorUnit val="0.1"/>
      </c:valAx>
    </c:plotArea>
    <c:legend>
      <c:legendPos val="b"/>
      <c:layout>
        <c:manualLayout>
          <c:xMode val="edge"/>
          <c:yMode val="edge"/>
          <c:x val="0.28254866726564842"/>
          <c:y val="0.63327767502957188"/>
          <c:w val="0.55534765897973448"/>
          <c:h val="0.36672232497042812"/>
        </c:manualLayout>
      </c:layout>
      <c:overlay val="0"/>
      <c:txPr>
        <a:bodyPr/>
        <a:lstStyle/>
        <a:p>
          <a:pPr>
            <a:defRPr sz="1000">
              <a:latin typeface="Arial" panose="020B0604020202020204" pitchFamily="34" charset="0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2 hs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D$292:$T$292</c:f>
                <c:numCache>
                  <c:formatCode>General</c:formatCode>
                  <c:ptCount val="17"/>
                  <c:pt idx="0">
                    <c:v>2.7982415111541266</c:v>
                  </c:pt>
                  <c:pt idx="1">
                    <c:v>2.3928497044983712</c:v>
                  </c:pt>
                  <c:pt idx="2">
                    <c:v>2.6910761676719597</c:v>
                  </c:pt>
                  <c:pt idx="3">
                    <c:v>5.0477671238580939</c:v>
                  </c:pt>
                  <c:pt idx="4">
                    <c:v>4.4592657715608945</c:v>
                  </c:pt>
                  <c:pt idx="5">
                    <c:v>0.94161229713259076</c:v>
                  </c:pt>
                  <c:pt idx="6">
                    <c:v>1.6931041277696246</c:v>
                  </c:pt>
                  <c:pt idx="7">
                    <c:v>3.0217961812314593</c:v>
                  </c:pt>
                  <c:pt idx="8">
                    <c:v>4.2310116514075258</c:v>
                  </c:pt>
                  <c:pt idx="9">
                    <c:v>6.3993661413405736</c:v>
                  </c:pt>
                  <c:pt idx="10">
                    <c:v>3.2876697011362603</c:v>
                  </c:pt>
                  <c:pt idx="11">
                    <c:v>3.752746191544118</c:v>
                  </c:pt>
                  <c:pt idx="12">
                    <c:v>7.1238220108791239</c:v>
                  </c:pt>
                  <c:pt idx="13">
                    <c:v>5.0128957590111405</c:v>
                  </c:pt>
                  <c:pt idx="14">
                    <c:v>4.9106407855473542</c:v>
                  </c:pt>
                  <c:pt idx="15">
                    <c:v>4.2127961907648777</c:v>
                  </c:pt>
                  <c:pt idx="16">
                    <c:v>2.6257659456464104</c:v>
                  </c:pt>
                </c:numCache>
              </c:numRef>
            </c:plus>
            <c:minus>
              <c:numRef>
                <c:f>Sheet1!$D$292:$T$292</c:f>
                <c:numCache>
                  <c:formatCode>General</c:formatCode>
                  <c:ptCount val="17"/>
                  <c:pt idx="0">
                    <c:v>2.7982415111541266</c:v>
                  </c:pt>
                  <c:pt idx="1">
                    <c:v>2.3928497044983712</c:v>
                  </c:pt>
                  <c:pt idx="2">
                    <c:v>2.6910761676719597</c:v>
                  </c:pt>
                  <c:pt idx="3">
                    <c:v>5.0477671238580939</c:v>
                  </c:pt>
                  <c:pt idx="4">
                    <c:v>4.4592657715608945</c:v>
                  </c:pt>
                  <c:pt idx="5">
                    <c:v>0.94161229713259076</c:v>
                  </c:pt>
                  <c:pt idx="6">
                    <c:v>1.6931041277696246</c:v>
                  </c:pt>
                  <c:pt idx="7">
                    <c:v>3.0217961812314593</c:v>
                  </c:pt>
                  <c:pt idx="8">
                    <c:v>4.2310116514075258</c:v>
                  </c:pt>
                  <c:pt idx="9">
                    <c:v>6.3993661413405736</c:v>
                  </c:pt>
                  <c:pt idx="10">
                    <c:v>3.2876697011362603</c:v>
                  </c:pt>
                  <c:pt idx="11">
                    <c:v>3.752746191544118</c:v>
                  </c:pt>
                  <c:pt idx="12">
                    <c:v>7.1238220108791239</c:v>
                  </c:pt>
                  <c:pt idx="13">
                    <c:v>5.0128957590111405</c:v>
                  </c:pt>
                  <c:pt idx="14">
                    <c:v>4.9106407855473542</c:v>
                  </c:pt>
                  <c:pt idx="15">
                    <c:v>4.2127961907648777</c:v>
                  </c:pt>
                  <c:pt idx="16">
                    <c:v>2.6257659456464104</c:v>
                  </c:pt>
                </c:numCache>
              </c:numRef>
            </c:minus>
          </c:errBars>
          <c:cat>
            <c:strRef>
              <c:f>Sheet1!$D$287:$T$287</c:f>
              <c:strCache>
                <c:ptCount val="17"/>
                <c:pt idx="0">
                  <c:v>HL</c:v>
                </c:pt>
                <c:pt idx="1">
                  <c:v>HL + rNm-ACPII</c:v>
                </c:pt>
                <c:pt idx="2">
                  <c:v>HL + rNm-ACPII + Ab(Lip-II)</c:v>
                </c:pt>
                <c:pt idx="3">
                  <c:v>rNm-ACPII + Ab(Lip-II)</c:v>
                </c:pt>
                <c:pt idx="4">
                  <c:v>HL + rNm-ACPII + Ab_cont.Lip</c:v>
                </c:pt>
                <c:pt idx="5">
                  <c:v>rNm-ACPII + Ab_cont.Lip</c:v>
                </c:pt>
                <c:pt idx="6">
                  <c:v>HL + rNm-ACPII + Ab(Sal-II)</c:v>
                </c:pt>
                <c:pt idx="7">
                  <c:v>rNm-ACPII + Ab(Sal-II)</c:v>
                </c:pt>
                <c:pt idx="8">
                  <c:v>HL + rNm-ACPII + Ab_cont.Sal</c:v>
                </c:pt>
                <c:pt idx="9">
                  <c:v>rNm-ACPII + Ab_cont.Sal</c:v>
                </c:pt>
                <c:pt idx="10">
                  <c:v>HL + rNm-ACPII + Ab(Al-II)</c:v>
                </c:pt>
                <c:pt idx="11">
                  <c:v>rNm-ACPII + Ab(Al-II)</c:v>
                </c:pt>
                <c:pt idx="12">
                  <c:v>HL + rNm-ACPII + Ab_cont.Al</c:v>
                </c:pt>
                <c:pt idx="13">
                  <c:v>rNm-ACPII + Ab_cont.Al</c:v>
                </c:pt>
                <c:pt idx="14">
                  <c:v>HL + rNm-ACPII + NMS</c:v>
                </c:pt>
                <c:pt idx="15">
                  <c:v>rNm-ACPII + NMS</c:v>
                </c:pt>
                <c:pt idx="16">
                  <c:v>HL + rNm-MIP</c:v>
                </c:pt>
              </c:strCache>
            </c:strRef>
          </c:cat>
          <c:val>
            <c:numRef>
              <c:f>Sheet1!$D$288:$T$288</c:f>
              <c:numCache>
                <c:formatCode>0.000</c:formatCode>
                <c:ptCount val="17"/>
                <c:pt idx="0">
                  <c:v>42.933235911629062</c:v>
                </c:pt>
                <c:pt idx="1">
                  <c:v>-0.73130810844102712</c:v>
                </c:pt>
                <c:pt idx="2">
                  <c:v>40.247433905232789</c:v>
                </c:pt>
                <c:pt idx="3">
                  <c:v>-1.0392307717372281E-2</c:v>
                </c:pt>
                <c:pt idx="4">
                  <c:v>0.90099786830066841</c:v>
                </c:pt>
                <c:pt idx="5">
                  <c:v>-0.18294197671797482</c:v>
                </c:pt>
                <c:pt idx="6">
                  <c:v>16.646214801976303</c:v>
                </c:pt>
                <c:pt idx="7">
                  <c:v>-1.7797043557225294</c:v>
                </c:pt>
                <c:pt idx="8">
                  <c:v>0.49266864197539445</c:v>
                </c:pt>
                <c:pt idx="9">
                  <c:v>-0.85671315536048098</c:v>
                </c:pt>
                <c:pt idx="10">
                  <c:v>40.007374762161589</c:v>
                </c:pt>
                <c:pt idx="11">
                  <c:v>-5.5149998389373467</c:v>
                </c:pt>
                <c:pt idx="12">
                  <c:v>-0.64148767380371885</c:v>
                </c:pt>
                <c:pt idx="13">
                  <c:v>-3.3179287921414726</c:v>
                </c:pt>
                <c:pt idx="14">
                  <c:v>2.1025323404008893</c:v>
                </c:pt>
                <c:pt idx="15">
                  <c:v>2.4806697638165693</c:v>
                </c:pt>
                <c:pt idx="16">
                  <c:v>39.64104758849225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overlap val="-25"/>
        <c:axId val="212163968"/>
        <c:axId val="213652608"/>
      </c:barChart>
      <c:catAx>
        <c:axId val="212163968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13652608"/>
        <c:crosses val="autoZero"/>
        <c:auto val="1"/>
        <c:lblAlgn val="ctr"/>
        <c:lblOffset val="100"/>
        <c:noMultiLvlLbl val="0"/>
      </c:catAx>
      <c:valAx>
        <c:axId val="213652608"/>
        <c:scaling>
          <c:orientation val="minMax"/>
          <c:max val="5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%</a:t>
                </a:r>
                <a:r>
                  <a:rPr lang="en-GB" sz="1200" baseline="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GB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ysis</a:t>
                </a:r>
                <a:endParaRPr lang="en-GB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1216396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9182B1-5C0B-48B7-9B10-4B637C07D29F}" type="datetimeFigureOut">
              <a:rPr lang="en-GB" smtClean="0"/>
              <a:t>16/05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5B3EC9-A064-4E75-831B-033DB2C2AA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441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9182B1-5C0B-48B7-9B10-4B637C07D29F}" type="datetimeFigureOut">
              <a:rPr lang="en-GB" smtClean="0"/>
              <a:t>16/05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5B3EC9-A064-4E75-831B-033DB2C2AA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09608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9182B1-5C0B-48B7-9B10-4B637C07D29F}" type="datetimeFigureOut">
              <a:rPr lang="en-GB" smtClean="0"/>
              <a:t>16/05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5B3EC9-A064-4E75-831B-033DB2C2AA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40624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9182B1-5C0B-48B7-9B10-4B637C07D29F}" type="datetimeFigureOut">
              <a:rPr lang="en-GB" smtClean="0"/>
              <a:t>16/05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5B3EC9-A064-4E75-831B-033DB2C2AA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44769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9182B1-5C0B-48B7-9B10-4B637C07D29F}" type="datetimeFigureOut">
              <a:rPr lang="en-GB" smtClean="0"/>
              <a:t>16/05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5B3EC9-A064-4E75-831B-033DB2C2AA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03417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9182B1-5C0B-48B7-9B10-4B637C07D29F}" type="datetimeFigureOut">
              <a:rPr lang="en-GB" smtClean="0"/>
              <a:t>16/05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5B3EC9-A064-4E75-831B-033DB2C2AA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37919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9182B1-5C0B-48B7-9B10-4B637C07D29F}" type="datetimeFigureOut">
              <a:rPr lang="en-GB" smtClean="0"/>
              <a:t>16/05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5B3EC9-A064-4E75-831B-033DB2C2AA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17184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9182B1-5C0B-48B7-9B10-4B637C07D29F}" type="datetimeFigureOut">
              <a:rPr lang="en-GB" smtClean="0"/>
              <a:t>16/05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5B3EC9-A064-4E75-831B-033DB2C2AA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383151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9182B1-5C0B-48B7-9B10-4B637C07D29F}" type="datetimeFigureOut">
              <a:rPr lang="en-GB" smtClean="0"/>
              <a:t>16/05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5B3EC9-A064-4E75-831B-033DB2C2AA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57720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9182B1-5C0B-48B7-9B10-4B637C07D29F}" type="datetimeFigureOut">
              <a:rPr lang="en-GB" smtClean="0"/>
              <a:t>16/05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5B3EC9-A064-4E75-831B-033DB2C2AA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99402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9182B1-5C0B-48B7-9B10-4B637C07D29F}" type="datetimeFigureOut">
              <a:rPr lang="en-GB" smtClean="0"/>
              <a:t>16/05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5B3EC9-A064-4E75-831B-033DB2C2AA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24391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9182B1-5C0B-48B7-9B10-4B637C07D29F}" type="datetimeFigureOut">
              <a:rPr lang="en-GB" smtClean="0"/>
              <a:t>16/05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5B3EC9-A064-4E75-831B-033DB2C2AA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00168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01179628"/>
              </p:ext>
            </p:extLst>
          </p:nvPr>
        </p:nvGraphicFramePr>
        <p:xfrm>
          <a:off x="-27309" y="622207"/>
          <a:ext cx="3934800" cy="4262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97208615"/>
              </p:ext>
            </p:extLst>
          </p:nvPr>
        </p:nvGraphicFramePr>
        <p:xfrm>
          <a:off x="3257675" y="622207"/>
          <a:ext cx="4006800" cy="48965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99206" y="288167"/>
            <a:ext cx="3738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401042" y="288167"/>
            <a:ext cx="3738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99206" y="4787865"/>
            <a:ext cx="3738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smtClean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-48248" y="5241032"/>
            <a:ext cx="6906249" cy="4449600"/>
            <a:chOff x="-48248" y="5241032"/>
            <a:chExt cx="6906249" cy="4449600"/>
          </a:xfrm>
        </p:grpSpPr>
        <p:graphicFrame>
          <p:nvGraphicFramePr>
            <p:cNvPr id="8" name="Chart 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31326362"/>
                </p:ext>
              </p:extLst>
            </p:nvPr>
          </p:nvGraphicFramePr>
          <p:xfrm>
            <a:off x="-48248" y="5241032"/>
            <a:ext cx="6906249" cy="4449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3" name="TextBox 12"/>
            <p:cNvSpPr txBox="1"/>
            <p:nvPr/>
          </p:nvSpPr>
          <p:spPr>
            <a:xfrm>
              <a:off x="5862414" y="5940921"/>
              <a:ext cx="7387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 h</a:t>
              </a:r>
              <a:endParaRPr lang="en-GB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Rectangle 13"/>
            <p:cNvSpPr/>
            <p:nvPr/>
          </p:nvSpPr>
          <p:spPr>
            <a:xfrm>
              <a:off x="5770215" y="6053995"/>
              <a:ext cx="72000" cy="72000"/>
            </a:xfrm>
            <a:prstGeom prst="rect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3188122" y="2329820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188122" y="2414473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188122" y="1647076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788655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8</TotalTime>
  <Words>35</Words>
  <Application>Microsoft Office PowerPoint</Application>
  <PresentationFormat>A4 Paper (210x297 mm)</PresentationFormat>
  <Paragraphs>1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Southampto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umbert M.V.</dc:creator>
  <cp:lastModifiedBy>Christodoulides M.</cp:lastModifiedBy>
  <cp:revision>21</cp:revision>
  <dcterms:created xsi:type="dcterms:W3CDTF">2016-06-11T15:48:42Z</dcterms:created>
  <dcterms:modified xsi:type="dcterms:W3CDTF">2017-05-16T07:45:23Z</dcterms:modified>
</cp:coreProperties>
</file>